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6" r:id="rId2"/>
    <p:sldId id="26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E4FF"/>
    <a:srgbClr val="2E75B6"/>
    <a:srgbClr val="B31310"/>
    <a:srgbClr val="B51917"/>
    <a:srgbClr val="000000"/>
    <a:srgbClr val="6A59D3"/>
    <a:srgbClr val="052F66"/>
    <a:srgbClr val="5F5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Style léger 1 - Accentuation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70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DFF41E-6446-4649-886A-5FE002780092}" type="datetimeFigureOut">
              <a:rPr lang="fr-FR" smtClean="0"/>
              <a:t>23/02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603DE5-9084-4ACE-9B29-E37AA28F59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29188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40E91F4-8532-41DE-9DBD-72F617FFB2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082F7C9-D776-49C1-8B37-ABCF439E47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204713C-41D9-492B-BC1F-B183A02E3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1C1D4-F5EB-44B0-B5E7-601DBD7FA1AD}" type="datetime1">
              <a:rPr lang="fr-FR" smtClean="0"/>
              <a:t>23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CF2C91-A3C8-46D1-9862-D34982990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053F865-0601-4CA0-841F-DC6F52C1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5867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7138A4-B5B3-4D07-956A-1F1FEF1BE4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78C9B91-9B9B-4AB7-8A36-088930334C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3136BE6-65E5-4B17-A495-B5A225329E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24E80-F7EA-4CAD-9D52-91B1995BC571}" type="datetime1">
              <a:rPr lang="fr-FR" smtClean="0"/>
              <a:t>23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89EC3E7-ADA3-4497-A153-DEE0DA0B4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21A62CE-2145-4D17-BA39-7F5AC9342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949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2654BE3-8690-4257-AC5B-DA05165684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F11DCC4-461F-4CF1-BF38-FEAB3DE706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8F387D3-06DE-4B64-8211-2D0B5A78D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E72E2-3FE9-4CAB-A50E-E63CCEAF80DD}" type="datetime1">
              <a:rPr lang="fr-FR" smtClean="0"/>
              <a:t>23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81E1E8E-7C80-49BA-B5C0-262274BCD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5C64DD3-8FB4-41C0-8E23-347236AA2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2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CC8B649-980A-4C25-8D2E-5FF09EACE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CCAD200-9543-48CE-A976-81FB859DFE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492D1D6-E782-4A5B-8F70-BC4DFBE38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4EAFB-5170-4126-BCEE-F6E4E1588868}" type="datetime1">
              <a:rPr lang="fr-FR" smtClean="0"/>
              <a:t>23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C517161-E073-4B24-96D5-25B5BD644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199DFD-2A8B-4059-8C8E-2258168C5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8633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956BBF1-79A4-44A2-97CA-58F1FD682F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740E3EF-FA09-4C1E-A327-8C05E98BF6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166BE1C-2C9C-490C-B95B-9D0C1A1A0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C4733-ACE6-413D-9C3E-1BB97AD6FCFC}" type="datetime1">
              <a:rPr lang="fr-FR" smtClean="0"/>
              <a:t>23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1CB62DE-F1F3-4EFF-8883-1561920C9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DDBBA1F-DA5C-4AA9-8FDF-53EDB10E9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2506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8123A16-AFE7-4821-92AC-EC21DCEC7A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A7BCD6A-2DF7-4D34-A0D1-4C9A970612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F8D5C9C-E50D-4842-9855-22DE5EAB47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B4DF9F0-7670-4804-B391-66564EEB9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223F6-B337-4491-9ACE-B4EEAACF7758}" type="datetime1">
              <a:rPr lang="fr-FR" smtClean="0"/>
              <a:t>23/0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2605A2C-C127-4FCC-A562-ABF8C9BFA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F4D998A-7A50-4704-B4A4-134077717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0958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73792A7-5F20-48F1-B2E6-985B69D9F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55EA5C3-E576-4227-95F2-47CB3E0921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45CCDBD-8EF6-476A-AB46-15C64C9E58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CA7C2A2-490F-4E8B-A780-54EA4C2816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52CC244-92D4-4E12-92D0-D1812E6548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1680478-A62A-480C-9A71-94CF53240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0D8F-BFA3-4CB9-AC43-6FFA5FD6A7C1}" type="datetime1">
              <a:rPr lang="fr-FR" smtClean="0"/>
              <a:t>23/02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45F530D-1043-4CA9-8BC9-40564877B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9F2B649-9D4B-423A-9EB7-73FF2324E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7446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CB98E1C-8BF1-49AA-AC93-B1DF3ACA64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9F4F7D2-0F16-4CBD-89AF-D5915ADE1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71C1-09B0-41CB-B060-0BB0E6958B61}" type="datetime1">
              <a:rPr lang="fr-FR" smtClean="0"/>
              <a:t>23/02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BBB6670-CF9B-4BAF-A10C-EDE90FDE7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FD69BDB-3777-41CB-AA7C-E44DABF5B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196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A11B2D1-54B0-4367-86AB-9BFC53BF2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C55FA-45E6-4662-B036-D8CA7753C354}" type="datetime1">
              <a:rPr lang="fr-FR" smtClean="0"/>
              <a:t>23/02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121299E-B549-43EE-8950-DCB386406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BAB97DE-1C61-4E07-B360-F975A2FC7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2491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928436-3894-4251-A7FC-43A5DB4FF0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042FA20-448C-41F7-A9F5-CF5105534F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788B222-35B9-4F4B-AEA0-380A0192B9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7EF8219-7B51-4D4A-95AC-C88EA5CAC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25BCE-8280-4D78-A758-091A57072D62}" type="datetime1">
              <a:rPr lang="fr-FR" smtClean="0"/>
              <a:t>23/0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23F9301-41BE-4584-B2E0-CAF815ACE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A3EBD62-AE32-47FC-86A4-B880104CF3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065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8A731E-C203-40BA-92FA-8AB01B4356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65F5FD0-F87D-41D5-9F9E-6E17BBE8AB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70EFB72-1F06-4496-B9E4-8D41FDDAFA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FAABBA0-D69C-48F2-9C8A-152868FD5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DAED5-CBF0-45B1-B1E3-0BAC736B29A4}" type="datetime1">
              <a:rPr lang="fr-FR" smtClean="0"/>
              <a:t>23/0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4543F86-4EA1-492B-85EF-C90622F7C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7BABFA1-8725-43DC-AAF2-8BFEF45AF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0802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C5BC799-1481-4A8A-AC40-69FBD114F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ABAE959-A900-42A8-BCE4-12A908C811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A9D5054-6DD3-4A14-B51E-900619CD32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14730-2A3A-4857-A300-86F921E96046}" type="datetime1">
              <a:rPr lang="fr-FR" smtClean="0"/>
              <a:t>23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0C9F006-CA1D-4E6A-A652-683720C9A6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80E92AE-9FDF-43CA-AC3A-6910D6DAC6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8194A-2738-4764-96E9-C9EC218814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6428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Espace réservé du numéro de diapositive 64">
            <a:extLst>
              <a:ext uri="{FF2B5EF4-FFF2-40B4-BE49-F238E27FC236}">
                <a16:creationId xmlns:a16="http://schemas.microsoft.com/office/drawing/2014/main" id="{151542E5-0AD7-4A18-A166-196916DA4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1</a:t>
            </a:fld>
            <a:endParaRPr lang="fr-FR"/>
          </a:p>
        </p:txBody>
      </p:sp>
      <p:cxnSp>
        <p:nvCxnSpPr>
          <p:cNvPr id="4" name="Connecteur droit 3">
            <a:extLst>
              <a:ext uri="{FF2B5EF4-FFF2-40B4-BE49-F238E27FC236}">
                <a16:creationId xmlns:a16="http://schemas.microsoft.com/office/drawing/2014/main" id="{C294AF67-5519-4C79-A22C-002AEAF1A144}"/>
              </a:ext>
            </a:extLst>
          </p:cNvPr>
          <p:cNvCxnSpPr/>
          <p:nvPr/>
        </p:nvCxnSpPr>
        <p:spPr>
          <a:xfrm flipV="1">
            <a:off x="3618840" y="1503835"/>
            <a:ext cx="0" cy="358140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5" name="Text Box 26">
            <a:extLst>
              <a:ext uri="{FF2B5EF4-FFF2-40B4-BE49-F238E27FC236}">
                <a16:creationId xmlns:a16="http://schemas.microsoft.com/office/drawing/2014/main" id="{0930A33C-F0D2-432B-AA40-D7FC12618A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03743" y="1865349"/>
            <a:ext cx="1539875" cy="700087"/>
          </a:xfrm>
          <a:prstGeom prst="rect">
            <a:avLst/>
          </a:prstGeom>
          <a:noFill/>
          <a:ln w="28575">
            <a:solidFill>
              <a:srgbClr val="9ACD32"/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rgbClr val="9ACD3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y 2</a:t>
            </a:r>
            <a:endParaRPr kumimoji="0" lang="en-US" altLang="fr-FR" sz="800" b="0" i="0" u="none" strike="noStrike" cap="none" normalizeH="0" baseline="0" dirty="0">
              <a:ln>
                <a:noFill/>
              </a:ln>
              <a:solidFill>
                <a:srgbClr val="9ACD32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9ACD3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withdrawal of 18 mangoes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rgbClr val="9ACD32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 Box 25">
            <a:extLst>
              <a:ext uri="{FF2B5EF4-FFF2-40B4-BE49-F238E27FC236}">
                <a16:creationId xmlns:a16="http://schemas.microsoft.com/office/drawing/2014/main" id="{E43453D3-69F0-4F15-8547-243367C758AF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2850121" y="2931293"/>
            <a:ext cx="936000" cy="701675"/>
          </a:xfrm>
          <a:prstGeom prst="rect">
            <a:avLst/>
          </a:prstGeom>
          <a:noFill/>
          <a:ln w="28575">
            <a:solidFill>
              <a:srgbClr val="B31310"/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>
                <a:ln>
                  <a:noFill/>
                </a:ln>
                <a:solidFill>
                  <a:srgbClr val="B3131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2.2</a:t>
            </a:r>
            <a:endParaRPr kumimoji="0" lang="en-US" altLang="fr-FR" sz="800" b="0" i="0" u="none" strike="noStrike" cap="none" normalizeH="0" baseline="0">
              <a:ln>
                <a:noFill/>
              </a:ln>
              <a:solidFill>
                <a:srgbClr val="B3131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>
                <a:ln>
                  <a:noFill/>
                </a:ln>
                <a:solidFill>
                  <a:srgbClr val="B3131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HD</a:t>
            </a:r>
            <a:endParaRPr kumimoji="0" lang="en-US" altLang="fr-FR" sz="1800" b="0" i="0" u="none" strike="noStrike" cap="none" normalizeH="0" baseline="0">
              <a:ln>
                <a:noFill/>
              </a:ln>
              <a:solidFill>
                <a:srgbClr val="B3131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Zone de texte 25">
            <a:extLst>
              <a:ext uri="{FF2B5EF4-FFF2-40B4-BE49-F238E27FC236}">
                <a16:creationId xmlns:a16="http://schemas.microsoft.com/office/drawing/2014/main" id="{DC885EC0-B093-44AD-9163-62FD49D4AE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9199" y="2930394"/>
            <a:ext cx="936000" cy="702000"/>
          </a:xfrm>
          <a:prstGeom prst="rect">
            <a:avLst/>
          </a:prstGeom>
          <a:noFill/>
          <a:ln w="285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1.2</a:t>
            </a:r>
            <a:endParaRPr kumimoji="0" lang="en-US" altLang="fr-F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SD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Connecteur droit avec flèche 7">
            <a:extLst>
              <a:ext uri="{FF2B5EF4-FFF2-40B4-BE49-F238E27FC236}">
                <a16:creationId xmlns:a16="http://schemas.microsoft.com/office/drawing/2014/main" id="{2DE726C9-9E07-4057-A8E9-1E9924F3FCF3}"/>
              </a:ext>
            </a:extLst>
          </p:cNvPr>
          <p:cNvCxnSpPr/>
          <p:nvPr/>
        </p:nvCxnSpPr>
        <p:spPr>
          <a:xfrm flipH="1">
            <a:off x="2469792" y="2560135"/>
            <a:ext cx="333375" cy="360000"/>
          </a:xfrm>
          <a:prstGeom prst="straightConnector1">
            <a:avLst/>
          </a:prstGeom>
          <a:ln w="28575">
            <a:solidFill>
              <a:srgbClr val="9ACD32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322C84C4-F372-4A59-9F1D-C0D18116490B}"/>
              </a:ext>
            </a:extLst>
          </p:cNvPr>
          <p:cNvCxnSpPr>
            <a:cxnSpLocks/>
          </p:cNvCxnSpPr>
          <p:nvPr/>
        </p:nvCxnSpPr>
        <p:spPr>
          <a:xfrm>
            <a:off x="4335100" y="2560135"/>
            <a:ext cx="200682" cy="341119"/>
          </a:xfrm>
          <a:prstGeom prst="straightConnector1">
            <a:avLst/>
          </a:prstGeom>
          <a:ln w="28575">
            <a:solidFill>
              <a:srgbClr val="9ACD32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 Box 27">
            <a:extLst>
              <a:ext uri="{FF2B5EF4-FFF2-40B4-BE49-F238E27FC236}">
                <a16:creationId xmlns:a16="http://schemas.microsoft.com/office/drawing/2014/main" id="{E8F70578-4DE7-4731-A553-9F59840E0D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5745" y="579355"/>
            <a:ext cx="1697455" cy="702001"/>
          </a:xfrm>
          <a:prstGeom prst="rect">
            <a:avLst/>
          </a:prstGeom>
          <a:noFill/>
          <a:ln w="285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0</a:t>
            </a:r>
            <a:r>
              <a:rPr kumimoji="0" lang="en-US" altLang="fr-FR" sz="1400" b="1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kumimoji="0" lang="en-US" altLang="fr-FR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ngoes harvested at ‘yellow point’ stage</a:t>
            </a:r>
            <a:endParaRPr kumimoji="0" lang="en-US" altLang="fr-FR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Connecteur droit avec flèche 10">
            <a:extLst>
              <a:ext uri="{FF2B5EF4-FFF2-40B4-BE49-F238E27FC236}">
                <a16:creationId xmlns:a16="http://schemas.microsoft.com/office/drawing/2014/main" id="{B5F54435-B96F-43D9-8B44-26445C0EB00B}"/>
              </a:ext>
            </a:extLst>
          </p:cNvPr>
          <p:cNvCxnSpPr>
            <a:cxnSpLocks/>
          </p:cNvCxnSpPr>
          <p:nvPr/>
        </p:nvCxnSpPr>
        <p:spPr>
          <a:xfrm flipV="1">
            <a:off x="2601199" y="1487845"/>
            <a:ext cx="7530995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2EC33492-5F66-436D-9444-9F9184BCB273}"/>
              </a:ext>
            </a:extLst>
          </p:cNvPr>
          <p:cNvCxnSpPr>
            <a:cxnSpLocks/>
            <a:stCxn id="5" idx="2"/>
          </p:cNvCxnSpPr>
          <p:nvPr/>
        </p:nvCxnSpPr>
        <p:spPr>
          <a:xfrm>
            <a:off x="3573681" y="2565436"/>
            <a:ext cx="0" cy="360000"/>
          </a:xfrm>
          <a:prstGeom prst="straightConnector1">
            <a:avLst/>
          </a:prstGeom>
          <a:ln w="28575">
            <a:solidFill>
              <a:srgbClr val="9ACD32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 Box 19">
            <a:extLst>
              <a:ext uri="{FF2B5EF4-FFF2-40B4-BE49-F238E27FC236}">
                <a16:creationId xmlns:a16="http://schemas.microsoft.com/office/drawing/2014/main" id="{DC68DA04-4200-419C-9EEA-6C16CEF06F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4651" y="1885130"/>
            <a:ext cx="1539875" cy="700088"/>
          </a:xfrm>
          <a:prstGeom prst="rect">
            <a:avLst/>
          </a:prstGeom>
          <a:noFill/>
          <a:ln w="28575">
            <a:solidFill>
              <a:srgbClr val="FFD700"/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rgbClr val="FFD7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y 4</a:t>
            </a:r>
            <a:endParaRPr kumimoji="0" lang="en-US" altLang="fr-FR" sz="800" b="0" i="0" u="none" strike="noStrike" cap="none" normalizeH="0" baseline="0" dirty="0">
              <a:ln>
                <a:noFill/>
              </a:ln>
              <a:solidFill>
                <a:srgbClr val="FFD7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D7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withdrawal of 18 mangoes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rgbClr val="FFD7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 Box 18">
            <a:extLst>
              <a:ext uri="{FF2B5EF4-FFF2-40B4-BE49-F238E27FC236}">
                <a16:creationId xmlns:a16="http://schemas.microsoft.com/office/drawing/2014/main" id="{2B0198C2-9839-4FB9-B01B-285AE732B9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81115" y="1888010"/>
            <a:ext cx="1539875" cy="700087"/>
          </a:xfrm>
          <a:prstGeom prst="rect">
            <a:avLst/>
          </a:prstGeom>
          <a:noFill/>
          <a:ln w="28575">
            <a:solidFill>
              <a:srgbClr val="FF8C00"/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rgbClr val="FF8C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y 6</a:t>
            </a:r>
            <a:endParaRPr kumimoji="0" lang="en-US" altLang="fr-FR" sz="800" b="0" i="0" u="none" strike="noStrike" cap="none" normalizeH="0" baseline="0" dirty="0">
              <a:ln>
                <a:noFill/>
              </a:ln>
              <a:solidFill>
                <a:srgbClr val="FF8C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rgbClr val="FF8C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withdrawal of 18 mangoes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rgbClr val="FF8C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E2B7C6FF-519B-403F-A08D-98EB3ABCA964}"/>
              </a:ext>
            </a:extLst>
          </p:cNvPr>
          <p:cNvCxnSpPr>
            <a:cxnSpLocks/>
          </p:cNvCxnSpPr>
          <p:nvPr/>
        </p:nvCxnSpPr>
        <p:spPr>
          <a:xfrm flipV="1">
            <a:off x="6405220" y="1503835"/>
            <a:ext cx="0" cy="375392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D84EFDD2-8F56-459B-B3E2-8993C4763678}"/>
              </a:ext>
            </a:extLst>
          </p:cNvPr>
          <p:cNvCxnSpPr/>
          <p:nvPr/>
        </p:nvCxnSpPr>
        <p:spPr>
          <a:xfrm flipH="1" flipV="1">
            <a:off x="9446870" y="1507010"/>
            <a:ext cx="0" cy="381000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7" name="Text Box 15">
            <a:extLst>
              <a:ext uri="{FF2B5EF4-FFF2-40B4-BE49-F238E27FC236}">
                <a16:creationId xmlns:a16="http://schemas.microsoft.com/office/drawing/2014/main" id="{49014FB6-1F9D-4814-ADBB-0529ADAC9C9B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857597" y="2932086"/>
            <a:ext cx="936000" cy="702000"/>
          </a:xfrm>
          <a:prstGeom prst="rect">
            <a:avLst/>
          </a:prstGeom>
          <a:noFill/>
          <a:ln w="28575">
            <a:solidFill>
              <a:schemeClr val="accent5">
                <a:lumMod val="75000"/>
              </a:schemeClr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 dirty="0">
                <a:ln>
                  <a:noFill/>
                </a:ln>
                <a:solidFill>
                  <a:srgbClr val="052F66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3.2</a:t>
            </a:r>
            <a:endParaRPr kumimoji="0" lang="en-US" altLang="fr-FR" sz="800" b="0" i="0" u="none" strike="noStrike" cap="none" normalizeH="0" baseline="0" dirty="0">
              <a:ln>
                <a:noFill/>
              </a:ln>
              <a:solidFill>
                <a:srgbClr val="052F66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 dirty="0">
                <a:ln>
                  <a:noFill/>
                </a:ln>
                <a:solidFill>
                  <a:srgbClr val="052F66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WD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rgbClr val="052F66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 Box 14">
            <a:extLst>
              <a:ext uri="{FF2B5EF4-FFF2-40B4-BE49-F238E27FC236}">
                <a16:creationId xmlns:a16="http://schemas.microsoft.com/office/drawing/2014/main" id="{58F1CDA5-EA81-46EB-BEE6-6EB3A98386F7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029301" y="2932879"/>
            <a:ext cx="936000" cy="702000"/>
          </a:xfrm>
          <a:prstGeom prst="rect">
            <a:avLst/>
          </a:prstGeom>
          <a:noFill/>
          <a:ln w="28575">
            <a:solidFill>
              <a:srgbClr val="B31310"/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>
                <a:ln>
                  <a:noFill/>
                </a:ln>
                <a:solidFill>
                  <a:srgbClr val="B3131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2.4</a:t>
            </a:r>
            <a:endParaRPr kumimoji="0" lang="en-US" altLang="fr-FR" sz="800" b="0" i="0" u="none" strike="noStrike" cap="none" normalizeH="0" baseline="0">
              <a:ln>
                <a:noFill/>
              </a:ln>
              <a:solidFill>
                <a:srgbClr val="B3131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>
                <a:ln>
                  <a:noFill/>
                </a:ln>
                <a:solidFill>
                  <a:srgbClr val="B3131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HD</a:t>
            </a:r>
            <a:endParaRPr kumimoji="0" lang="en-US" altLang="fr-FR" sz="1800" b="0" i="0" u="none" strike="noStrike" cap="none" normalizeH="0" baseline="0">
              <a:ln>
                <a:noFill/>
              </a:ln>
              <a:solidFill>
                <a:srgbClr val="B3131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 Box 13">
            <a:extLst>
              <a:ext uri="{FF2B5EF4-FFF2-40B4-BE49-F238E27FC236}">
                <a16:creationId xmlns:a16="http://schemas.microsoft.com/office/drawing/2014/main" id="{3097E0A2-406A-49CD-94A9-C328378D86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2826" y="2932880"/>
            <a:ext cx="936000" cy="702000"/>
          </a:xfrm>
          <a:prstGeom prst="rect">
            <a:avLst/>
          </a:prstGeom>
          <a:noFill/>
          <a:ln w="285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1.4</a:t>
            </a:r>
            <a:endParaRPr kumimoji="0" lang="en-US" altLang="fr-FR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SD</a:t>
            </a:r>
            <a:endParaRPr kumimoji="0" lang="en-US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 Box 12">
            <a:extLst>
              <a:ext uri="{FF2B5EF4-FFF2-40B4-BE49-F238E27FC236}">
                <a16:creationId xmlns:a16="http://schemas.microsoft.com/office/drawing/2014/main" id="{0B920F8B-E745-4AB1-A2E3-BCCF5E163603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7034188" y="2930393"/>
            <a:ext cx="936000" cy="702000"/>
          </a:xfrm>
          <a:prstGeom prst="rect">
            <a:avLst/>
          </a:prstGeom>
          <a:noFill/>
          <a:ln w="28575">
            <a:solidFill>
              <a:schemeClr val="accent5">
                <a:lumMod val="75000"/>
              </a:schemeClr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>
                <a:ln>
                  <a:noFill/>
                </a:ln>
                <a:solidFill>
                  <a:srgbClr val="052F66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3.4</a:t>
            </a:r>
            <a:endParaRPr kumimoji="0" lang="en-US" altLang="fr-FR" sz="800" b="0" i="0" u="none" strike="noStrike" cap="none" normalizeH="0" baseline="0">
              <a:ln>
                <a:noFill/>
              </a:ln>
              <a:solidFill>
                <a:srgbClr val="052F66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>
                <a:ln>
                  <a:noFill/>
                </a:ln>
                <a:solidFill>
                  <a:srgbClr val="052F66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WD</a:t>
            </a:r>
            <a:endParaRPr kumimoji="0" lang="en-US" altLang="fr-FR" sz="1800" b="0" i="0" u="none" strike="noStrike" cap="none" normalizeH="0" baseline="0">
              <a:ln>
                <a:noFill/>
              </a:ln>
              <a:solidFill>
                <a:srgbClr val="052F66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 Box 11">
            <a:extLst>
              <a:ext uri="{FF2B5EF4-FFF2-40B4-BE49-F238E27FC236}">
                <a16:creationId xmlns:a16="http://schemas.microsoft.com/office/drawing/2014/main" id="{22D07FFD-3AD8-49B1-A6D6-67A30A4B2F11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9218587" y="2928118"/>
            <a:ext cx="974725" cy="708025"/>
          </a:xfrm>
          <a:prstGeom prst="rect">
            <a:avLst/>
          </a:prstGeom>
          <a:noFill/>
          <a:ln w="28575">
            <a:solidFill>
              <a:srgbClr val="B31310"/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 dirty="0">
                <a:ln>
                  <a:noFill/>
                </a:ln>
                <a:solidFill>
                  <a:srgbClr val="B3131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2.6</a:t>
            </a:r>
            <a:endParaRPr kumimoji="0" lang="en-US" altLang="fr-FR" sz="800" b="0" i="0" u="none" strike="noStrike" cap="none" normalizeH="0" baseline="0" dirty="0">
              <a:ln>
                <a:noFill/>
              </a:ln>
              <a:solidFill>
                <a:srgbClr val="B3131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 dirty="0">
                <a:ln>
                  <a:noFill/>
                </a:ln>
                <a:solidFill>
                  <a:srgbClr val="B3131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HD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rgbClr val="B3131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 Box 10">
            <a:extLst>
              <a:ext uri="{FF2B5EF4-FFF2-40B4-BE49-F238E27FC236}">
                <a16:creationId xmlns:a16="http://schemas.microsoft.com/office/drawing/2014/main" id="{ECB542A2-2D69-401B-9363-9B308329AD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10526" y="2929705"/>
            <a:ext cx="936000" cy="702000"/>
          </a:xfrm>
          <a:prstGeom prst="rect">
            <a:avLst/>
          </a:prstGeom>
          <a:noFill/>
          <a:ln w="285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1.6</a:t>
            </a:r>
            <a:endParaRPr kumimoji="0" lang="en-US" altLang="fr-F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SD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 Box 9">
            <a:extLst>
              <a:ext uri="{FF2B5EF4-FFF2-40B4-BE49-F238E27FC236}">
                <a16:creationId xmlns:a16="http://schemas.microsoft.com/office/drawing/2014/main" id="{4D37D82F-A1A5-4A36-9F04-B403C11200A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10267234" y="2934468"/>
            <a:ext cx="974725" cy="701675"/>
          </a:xfrm>
          <a:prstGeom prst="rect">
            <a:avLst/>
          </a:prstGeom>
          <a:noFill/>
          <a:ln w="28575">
            <a:solidFill>
              <a:schemeClr val="accent5">
                <a:lumMod val="75000"/>
              </a:schemeClr>
            </a:solidFill>
            <a:miter lim="800000"/>
            <a:headEnd/>
            <a:tailEnd/>
          </a:ln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1" u="none" strike="noStrike" cap="none" normalizeH="0" baseline="0">
                <a:ln>
                  <a:noFill/>
                </a:ln>
                <a:solidFill>
                  <a:srgbClr val="052F66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 3.6</a:t>
            </a:r>
            <a:endParaRPr kumimoji="0" lang="en-US" altLang="fr-FR" sz="800" b="0" i="0" u="none" strike="noStrike" cap="none" normalizeH="0" baseline="0">
              <a:ln>
                <a:noFill/>
              </a:ln>
              <a:solidFill>
                <a:srgbClr val="052F66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1" u="none" strike="noStrike" cap="none" normalizeH="0" baseline="0">
                <a:ln>
                  <a:noFill/>
                </a:ln>
                <a:solidFill>
                  <a:srgbClr val="052F66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mangoes for WD</a:t>
            </a:r>
            <a:endParaRPr kumimoji="0" lang="en-US" altLang="fr-FR" sz="1800" b="0" i="0" u="none" strike="noStrike" cap="none" normalizeH="0" baseline="0">
              <a:ln>
                <a:noFill/>
              </a:ln>
              <a:solidFill>
                <a:srgbClr val="052F66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Connecteur droit avec flèche 23">
            <a:extLst>
              <a:ext uri="{FF2B5EF4-FFF2-40B4-BE49-F238E27FC236}">
                <a16:creationId xmlns:a16="http://schemas.microsoft.com/office/drawing/2014/main" id="{55891B25-4C7D-4359-8CB7-F3CD251AE001}"/>
              </a:ext>
            </a:extLst>
          </p:cNvPr>
          <p:cNvCxnSpPr/>
          <p:nvPr/>
        </p:nvCxnSpPr>
        <p:spPr>
          <a:xfrm flipH="1">
            <a:off x="5329128" y="2581461"/>
            <a:ext cx="333375" cy="323215"/>
          </a:xfrm>
          <a:prstGeom prst="straightConnector1">
            <a:avLst/>
          </a:prstGeom>
          <a:ln w="28575">
            <a:solidFill>
              <a:srgbClr val="FFD7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necteur droit avec flèche 24">
            <a:extLst>
              <a:ext uri="{FF2B5EF4-FFF2-40B4-BE49-F238E27FC236}">
                <a16:creationId xmlns:a16="http://schemas.microsoft.com/office/drawing/2014/main" id="{E9111EF7-5C70-4AE0-B214-59758A34753A}"/>
              </a:ext>
            </a:extLst>
          </p:cNvPr>
          <p:cNvCxnSpPr/>
          <p:nvPr/>
        </p:nvCxnSpPr>
        <p:spPr>
          <a:xfrm>
            <a:off x="7181365" y="2570453"/>
            <a:ext cx="315595" cy="324000"/>
          </a:xfrm>
          <a:prstGeom prst="straightConnector1">
            <a:avLst/>
          </a:prstGeom>
          <a:ln w="28575">
            <a:solidFill>
              <a:srgbClr val="FFD7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Connecteur droit avec flèche 25">
            <a:extLst>
              <a:ext uri="{FF2B5EF4-FFF2-40B4-BE49-F238E27FC236}">
                <a16:creationId xmlns:a16="http://schemas.microsoft.com/office/drawing/2014/main" id="{92016474-227C-4359-9910-477FFA613FD6}"/>
              </a:ext>
            </a:extLst>
          </p:cNvPr>
          <p:cNvCxnSpPr>
            <a:cxnSpLocks/>
            <a:stCxn id="13" idx="2"/>
          </p:cNvCxnSpPr>
          <p:nvPr/>
        </p:nvCxnSpPr>
        <p:spPr>
          <a:xfrm flipH="1">
            <a:off x="6414745" y="2585218"/>
            <a:ext cx="0" cy="338137"/>
          </a:xfrm>
          <a:prstGeom prst="straightConnector1">
            <a:avLst/>
          </a:prstGeom>
          <a:ln w="28575">
            <a:solidFill>
              <a:srgbClr val="FFD7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Connecteur droit avec flèche 26">
            <a:extLst>
              <a:ext uri="{FF2B5EF4-FFF2-40B4-BE49-F238E27FC236}">
                <a16:creationId xmlns:a16="http://schemas.microsoft.com/office/drawing/2014/main" id="{8E34C3BD-51E9-4418-A71D-E9746CEE085E}"/>
              </a:ext>
            </a:extLst>
          </p:cNvPr>
          <p:cNvCxnSpPr/>
          <p:nvPr/>
        </p:nvCxnSpPr>
        <p:spPr>
          <a:xfrm flipH="1">
            <a:off x="8422299" y="2578266"/>
            <a:ext cx="250190" cy="314960"/>
          </a:xfrm>
          <a:prstGeom prst="straightConnector1">
            <a:avLst/>
          </a:prstGeom>
          <a:ln w="28575">
            <a:solidFill>
              <a:srgbClr val="FF8C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Connecteur droit avec flèche 27">
            <a:extLst>
              <a:ext uri="{FF2B5EF4-FFF2-40B4-BE49-F238E27FC236}">
                <a16:creationId xmlns:a16="http://schemas.microsoft.com/office/drawing/2014/main" id="{76460B5A-E0CF-4378-AE4F-B49F1A6A1BB7}"/>
              </a:ext>
            </a:extLst>
          </p:cNvPr>
          <p:cNvCxnSpPr>
            <a:cxnSpLocks/>
          </p:cNvCxnSpPr>
          <p:nvPr/>
        </p:nvCxnSpPr>
        <p:spPr>
          <a:xfrm>
            <a:off x="10229616" y="2602657"/>
            <a:ext cx="223467" cy="302019"/>
          </a:xfrm>
          <a:prstGeom prst="straightConnector1">
            <a:avLst/>
          </a:prstGeom>
          <a:ln w="28575">
            <a:solidFill>
              <a:srgbClr val="FF8C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Connecteur droit avec flèche 28">
            <a:extLst>
              <a:ext uri="{FF2B5EF4-FFF2-40B4-BE49-F238E27FC236}">
                <a16:creationId xmlns:a16="http://schemas.microsoft.com/office/drawing/2014/main" id="{1E1CFD9F-7A48-4B8D-AD5F-38FE70125BE8}"/>
              </a:ext>
            </a:extLst>
          </p:cNvPr>
          <p:cNvCxnSpPr>
            <a:cxnSpLocks/>
            <a:stCxn id="14" idx="2"/>
          </p:cNvCxnSpPr>
          <p:nvPr/>
        </p:nvCxnSpPr>
        <p:spPr>
          <a:xfrm>
            <a:off x="9451053" y="2588097"/>
            <a:ext cx="0" cy="335258"/>
          </a:xfrm>
          <a:prstGeom prst="straightConnector1">
            <a:avLst/>
          </a:prstGeom>
          <a:ln w="28575">
            <a:solidFill>
              <a:srgbClr val="FF8C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CF86FF55-CFDC-440B-837F-0AF6F66CCFA6}"/>
              </a:ext>
            </a:extLst>
          </p:cNvPr>
          <p:cNvCxnSpPr>
            <a:cxnSpLocks/>
          </p:cNvCxnSpPr>
          <p:nvPr/>
        </p:nvCxnSpPr>
        <p:spPr>
          <a:xfrm flipV="1">
            <a:off x="2601199" y="1278873"/>
            <a:ext cx="0" cy="218485"/>
          </a:xfrm>
          <a:prstGeom prst="line">
            <a:avLst/>
          </a:prstGeom>
          <a:noFill/>
          <a:ln w="28575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D4866C60-FDAC-41B9-9F3E-8B2C275C8F21}"/>
              </a:ext>
            </a:extLst>
          </p:cNvPr>
          <p:cNvSpPr/>
          <p:nvPr/>
        </p:nvSpPr>
        <p:spPr>
          <a:xfrm>
            <a:off x="1725797" y="52575"/>
            <a:ext cx="9580982" cy="2766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Experimental design and distribution of the fruits of different maturity degrees in each batch for the 3 drying schemes.</a:t>
            </a:r>
            <a:endParaRPr lang="fr-F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Organigramme : Terminateur 1">
            <a:extLst>
              <a:ext uri="{FF2B5EF4-FFF2-40B4-BE49-F238E27FC236}">
                <a16:creationId xmlns:a16="http://schemas.microsoft.com/office/drawing/2014/main" id="{B33B5B61-D90D-42C0-9C12-54F284D22E6A}"/>
              </a:ext>
            </a:extLst>
          </p:cNvPr>
          <p:cNvSpPr/>
          <p:nvPr/>
        </p:nvSpPr>
        <p:spPr>
          <a:xfrm>
            <a:off x="3447358" y="923530"/>
            <a:ext cx="6684835" cy="355343"/>
          </a:xfrm>
          <a:prstGeom prst="flowChartTerminator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pening</a:t>
            </a:r>
            <a:r>
              <a:rPr lang="fr-F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t 20 °C</a:t>
            </a:r>
          </a:p>
        </p:txBody>
      </p:sp>
      <p:sp>
        <p:nvSpPr>
          <p:cNvPr id="49" name="Text Box 1">
            <a:extLst>
              <a:ext uri="{FF2B5EF4-FFF2-40B4-BE49-F238E27FC236}">
                <a16:creationId xmlns:a16="http://schemas.microsoft.com/office/drawing/2014/main" id="{16B066C4-CD3C-4C07-BD98-6AD6A3B3A6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539" y="4182596"/>
            <a:ext cx="1863725" cy="118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r-FR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drying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r-FR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es</a:t>
            </a:r>
            <a:endParaRPr kumimoji="0" lang="en-US" altLang="fr-FR" sz="13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Organigramme : Terminateur 37">
            <a:extLst>
              <a:ext uri="{FF2B5EF4-FFF2-40B4-BE49-F238E27FC236}">
                <a16:creationId xmlns:a16="http://schemas.microsoft.com/office/drawing/2014/main" id="{28F30DA6-37A4-4C4C-84B3-71E0771C9146}"/>
              </a:ext>
            </a:extLst>
          </p:cNvPr>
          <p:cNvSpPr/>
          <p:nvPr/>
        </p:nvSpPr>
        <p:spPr>
          <a:xfrm>
            <a:off x="2112264" y="3766712"/>
            <a:ext cx="8970264" cy="355343"/>
          </a:xfrm>
          <a:prstGeom prst="flowChartTerminator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dirty="0">
                <a:solidFill>
                  <a:schemeClr val="tx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orage at 12°C from the sampling day to the day of drying</a:t>
            </a:r>
            <a:endParaRPr lang="en-US" altLang="fr-FR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Connecteur droit avec flèche 38">
            <a:extLst>
              <a:ext uri="{FF2B5EF4-FFF2-40B4-BE49-F238E27FC236}">
                <a16:creationId xmlns:a16="http://schemas.microsoft.com/office/drawing/2014/main" id="{5A60D53F-B831-4DBC-9AA2-1AC5C5E11B8D}"/>
              </a:ext>
            </a:extLst>
          </p:cNvPr>
          <p:cNvCxnSpPr>
            <a:cxnSpLocks/>
          </p:cNvCxnSpPr>
          <p:nvPr/>
        </p:nvCxnSpPr>
        <p:spPr>
          <a:xfrm flipH="1">
            <a:off x="3363200" y="4133859"/>
            <a:ext cx="193502" cy="262518"/>
          </a:xfrm>
          <a:prstGeom prst="straightConnector1">
            <a:avLst/>
          </a:prstGeom>
          <a:ln w="28575">
            <a:solidFill>
              <a:srgbClr val="00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Connecteur droit avec flèche 41">
            <a:extLst>
              <a:ext uri="{FF2B5EF4-FFF2-40B4-BE49-F238E27FC236}">
                <a16:creationId xmlns:a16="http://schemas.microsoft.com/office/drawing/2014/main" id="{03507019-F790-42B2-8110-41E525F0CF0E}"/>
              </a:ext>
            </a:extLst>
          </p:cNvPr>
          <p:cNvCxnSpPr>
            <a:cxnSpLocks/>
            <a:stCxn id="38" idx="2"/>
          </p:cNvCxnSpPr>
          <p:nvPr/>
        </p:nvCxnSpPr>
        <p:spPr>
          <a:xfrm flipH="1">
            <a:off x="6536597" y="4122055"/>
            <a:ext cx="0" cy="271418"/>
          </a:xfrm>
          <a:prstGeom prst="straightConnector1">
            <a:avLst/>
          </a:prstGeom>
          <a:ln w="28575">
            <a:solidFill>
              <a:srgbClr val="B51917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Connecteur droit avec flèche 44">
            <a:extLst>
              <a:ext uri="{FF2B5EF4-FFF2-40B4-BE49-F238E27FC236}">
                <a16:creationId xmlns:a16="http://schemas.microsoft.com/office/drawing/2014/main" id="{CBD1C7AD-3ACF-45BA-826B-DA108090D74E}"/>
              </a:ext>
            </a:extLst>
          </p:cNvPr>
          <p:cNvCxnSpPr>
            <a:cxnSpLocks/>
          </p:cNvCxnSpPr>
          <p:nvPr/>
        </p:nvCxnSpPr>
        <p:spPr>
          <a:xfrm>
            <a:off x="9671668" y="4117483"/>
            <a:ext cx="66338" cy="266846"/>
          </a:xfrm>
          <a:prstGeom prst="straightConnector1">
            <a:avLst/>
          </a:prstGeom>
          <a:ln w="28575">
            <a:solidFill>
              <a:schemeClr val="accent5">
                <a:lumMod val="75000"/>
              </a:schemeClr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Accolade ouvrante 36">
            <a:extLst>
              <a:ext uri="{FF2B5EF4-FFF2-40B4-BE49-F238E27FC236}">
                <a16:creationId xmlns:a16="http://schemas.microsoft.com/office/drawing/2014/main" id="{3295E7DC-EFE5-42E4-AD5D-A50F2F074D66}"/>
              </a:ext>
            </a:extLst>
          </p:cNvPr>
          <p:cNvSpPr/>
          <p:nvPr/>
        </p:nvSpPr>
        <p:spPr>
          <a:xfrm>
            <a:off x="1665745" y="4402617"/>
            <a:ext cx="120104" cy="825137"/>
          </a:xfrm>
          <a:prstGeom prst="leftBrace">
            <a:avLst>
              <a:gd name="adj1" fmla="val 171755"/>
              <a:gd name="adj2" fmla="val 50000"/>
            </a:avLst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40" name="Tableau 39">
            <a:extLst>
              <a:ext uri="{FF2B5EF4-FFF2-40B4-BE49-F238E27FC236}">
                <a16:creationId xmlns:a16="http://schemas.microsoft.com/office/drawing/2014/main" id="{D41E89EE-A2AF-4487-A710-5A57355184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5298109"/>
              </p:ext>
            </p:extLst>
          </p:nvPr>
        </p:nvGraphicFramePr>
        <p:xfrm>
          <a:off x="5829154" y="5325081"/>
          <a:ext cx="4342540" cy="128016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171270">
                  <a:extLst>
                    <a:ext uri="{9D8B030D-6E8A-4147-A177-3AD203B41FA5}">
                      <a16:colId xmlns:a16="http://schemas.microsoft.com/office/drawing/2014/main" val="2992512518"/>
                    </a:ext>
                  </a:extLst>
                </a:gridCol>
                <a:gridCol w="2171270">
                  <a:extLst>
                    <a:ext uri="{9D8B030D-6E8A-4147-A177-3AD203B41FA5}">
                      <a16:colId xmlns:a16="http://schemas.microsoft.com/office/drawing/2014/main" val="3851752250"/>
                    </a:ext>
                  </a:extLst>
                </a:gridCol>
              </a:tblGrid>
              <a:tr h="215588">
                <a:tc>
                  <a:txBody>
                    <a:bodyPr/>
                    <a:lstStyle/>
                    <a:p>
                      <a:r>
                        <a:rPr lang="fr-FR" sz="1200" dirty="0" err="1"/>
                        <a:t>Parameters</a:t>
                      </a:r>
                      <a:r>
                        <a:rPr lang="fr-FR" sz="1200" dirty="0"/>
                        <a:t> 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sz="1200" dirty="0"/>
                        <a:t>Equipment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4002466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r>
                        <a:rPr lang="fr-FR" sz="1200" dirty="0"/>
                        <a:t>°Brix 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</a:rPr>
                        <a:t>PAL-α, </a:t>
                      </a:r>
                      <a:r>
                        <a:rPr lang="en-US" sz="1200" kern="1200" dirty="0" err="1">
                          <a:effectLst/>
                        </a:rPr>
                        <a:t>Atago</a:t>
                      </a:r>
                      <a:r>
                        <a:rPr lang="en-US" sz="1200" kern="1200" dirty="0">
                          <a:effectLst/>
                        </a:rPr>
                        <a:t>, Tokyo, Japan</a:t>
                      </a:r>
                      <a:endParaRPr lang="fr-FR" sz="1200" dirty="0"/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5822195"/>
                  </a:ext>
                </a:extLst>
              </a:tr>
              <a:tr h="359313">
                <a:tc>
                  <a:txBody>
                    <a:bodyPr/>
                    <a:lstStyle/>
                    <a:p>
                      <a:r>
                        <a:rPr lang="fr-FR" sz="1200" dirty="0"/>
                        <a:t>pH and </a:t>
                      </a:r>
                      <a:r>
                        <a:rPr lang="fr-FR" sz="1200" dirty="0" err="1"/>
                        <a:t>titratable</a:t>
                      </a:r>
                      <a:r>
                        <a:rPr lang="fr-FR" sz="1200" dirty="0"/>
                        <a:t> </a:t>
                      </a:r>
                      <a:r>
                        <a:rPr lang="fr-FR" sz="1200" dirty="0" err="1"/>
                        <a:t>acidity</a:t>
                      </a:r>
                      <a:endParaRPr lang="fr-FR" sz="1200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err="1">
                          <a:effectLst/>
                        </a:rPr>
                        <a:t>TitroLine</a:t>
                      </a:r>
                      <a:r>
                        <a:rPr lang="en-US" sz="1200" kern="1200" dirty="0">
                          <a:effectLst/>
                        </a:rPr>
                        <a:t>, Schott Instruments, Mainz, Germany</a:t>
                      </a:r>
                      <a:endParaRPr lang="fr-FR" sz="1200" dirty="0"/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9237070"/>
                  </a:ext>
                </a:extLst>
              </a:tr>
              <a:tr h="215588">
                <a:tc>
                  <a:txBody>
                    <a:bodyPr/>
                    <a:lstStyle/>
                    <a:p>
                      <a:r>
                        <a:rPr lang="fr-FR" sz="1200" dirty="0"/>
                        <a:t>Color index : L*, C* and H*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</a:rPr>
                        <a:t>Minolta CR-410, Tokyo, Japan</a:t>
                      </a:r>
                      <a:endParaRPr lang="fr-FR" sz="1200" dirty="0"/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1066929"/>
                  </a:ext>
                </a:extLst>
              </a:tr>
            </a:tbl>
          </a:graphicData>
        </a:graphic>
      </p:graphicFrame>
      <p:sp>
        <p:nvSpPr>
          <p:cNvPr id="43" name="Text Box 1">
            <a:extLst>
              <a:ext uri="{FF2B5EF4-FFF2-40B4-BE49-F238E27FC236}">
                <a16:creationId xmlns:a16="http://schemas.microsoft.com/office/drawing/2014/main" id="{EA43D689-E06D-4324-AD4C-A3CCCD160A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5586" y="5815506"/>
            <a:ext cx="3603568" cy="4234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72000" tIns="72000" rIns="72000" bIns="72000" numCol="1" anchor="ctr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*) 4 slices per mango were sampled for drying </a:t>
            </a:r>
          </a:p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olor measurements. The remaining fresh pulp were individually kept for </a:t>
            </a:r>
            <a:r>
              <a:rPr lang="en-US" alt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sico</a:t>
            </a:r>
            <a:r>
              <a:rPr lang="en-US" alt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hemical analysis</a:t>
            </a:r>
            <a:endParaRPr kumimoji="0" lang="en-US" altLang="fr-F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CDEB5E91-383A-4A82-9A49-30FC93D2517D}"/>
              </a:ext>
            </a:extLst>
          </p:cNvPr>
          <p:cNvSpPr/>
          <p:nvPr/>
        </p:nvSpPr>
        <p:spPr>
          <a:xfrm>
            <a:off x="3422484" y="4145329"/>
            <a:ext cx="3642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*)</a:t>
            </a:r>
            <a:endParaRPr lang="fr-FR" sz="1200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C83C60AC-4509-4686-9E62-72D0452ED4DB}"/>
              </a:ext>
            </a:extLst>
          </p:cNvPr>
          <p:cNvSpPr/>
          <p:nvPr/>
        </p:nvSpPr>
        <p:spPr>
          <a:xfrm>
            <a:off x="6491589" y="4110998"/>
            <a:ext cx="3642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>
                <a:solidFill>
                  <a:srgbClr val="B3131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*)</a:t>
            </a:r>
            <a:endParaRPr lang="fr-FR" sz="1200" dirty="0">
              <a:solidFill>
                <a:srgbClr val="B31310"/>
              </a:solidFill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2D897EBF-FD96-442C-A2A3-A913DC54EEF2}"/>
              </a:ext>
            </a:extLst>
          </p:cNvPr>
          <p:cNvSpPr/>
          <p:nvPr/>
        </p:nvSpPr>
        <p:spPr>
          <a:xfrm>
            <a:off x="9671668" y="4127040"/>
            <a:ext cx="3642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fr-FR" sz="1200" b="1" dirty="0">
                <a:solidFill>
                  <a:schemeClr val="accent5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*)</a:t>
            </a:r>
            <a:endParaRPr lang="fr-FR" sz="1200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48" name="Organigramme : Terminateur 47">
            <a:extLst>
              <a:ext uri="{FF2B5EF4-FFF2-40B4-BE49-F238E27FC236}">
                <a16:creationId xmlns:a16="http://schemas.microsoft.com/office/drawing/2014/main" id="{EA53F01A-A708-457B-B70C-AAB60A0702C4}"/>
              </a:ext>
            </a:extLst>
          </p:cNvPr>
          <p:cNvSpPr/>
          <p:nvPr/>
        </p:nvSpPr>
        <p:spPr>
          <a:xfrm>
            <a:off x="1877352" y="4427968"/>
            <a:ext cx="2881537" cy="832667"/>
          </a:xfrm>
          <a:prstGeom prst="flowChartTerminator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chemeClr val="tx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es :  1.2, 1.4, 1.6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chemeClr val="tx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D : Standard Drying 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 °C / 30 % RH / 5h</a:t>
            </a:r>
            <a:endParaRPr lang="fr-FR" sz="1400" dirty="0">
              <a:ln>
                <a:solidFill>
                  <a:sysClr val="windowText" lastClr="000000"/>
                </a:solidFill>
              </a:ln>
              <a:solidFill>
                <a:sysClr val="windowText" lastClr="000000"/>
              </a:solidFill>
            </a:endParaRPr>
          </a:p>
        </p:txBody>
      </p:sp>
      <p:sp>
        <p:nvSpPr>
          <p:cNvPr id="51" name="Organigramme : Terminateur 50">
            <a:extLst>
              <a:ext uri="{FF2B5EF4-FFF2-40B4-BE49-F238E27FC236}">
                <a16:creationId xmlns:a16="http://schemas.microsoft.com/office/drawing/2014/main" id="{91A54985-74C6-41D2-8E50-EFE42C7A9FF0}"/>
              </a:ext>
            </a:extLst>
          </p:cNvPr>
          <p:cNvSpPr/>
          <p:nvPr/>
        </p:nvSpPr>
        <p:spPr>
          <a:xfrm>
            <a:off x="5101131" y="4384329"/>
            <a:ext cx="2881537" cy="832667"/>
          </a:xfrm>
          <a:prstGeom prst="flowChartTerminator">
            <a:avLst/>
          </a:prstGeom>
          <a:noFill/>
          <a:ln w="28575">
            <a:solidFill>
              <a:srgbClr val="B3131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rgbClr val="B3131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es :  2.2, 2.4, 2.6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rgbClr val="B3131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D : Hot Drying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 °C / 30% RH / 4h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rgbClr val="B3131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0 °C / 30% RH / 1h</a:t>
            </a:r>
          </a:p>
        </p:txBody>
      </p:sp>
      <p:sp>
        <p:nvSpPr>
          <p:cNvPr id="52" name="Organigramme : Terminateur 51">
            <a:extLst>
              <a:ext uri="{FF2B5EF4-FFF2-40B4-BE49-F238E27FC236}">
                <a16:creationId xmlns:a16="http://schemas.microsoft.com/office/drawing/2014/main" id="{9622DE82-0560-45EC-951B-E19F6D199E67}"/>
              </a:ext>
            </a:extLst>
          </p:cNvPr>
          <p:cNvSpPr/>
          <p:nvPr/>
        </p:nvSpPr>
        <p:spPr>
          <a:xfrm>
            <a:off x="8295995" y="4393986"/>
            <a:ext cx="2881537" cy="832667"/>
          </a:xfrm>
          <a:prstGeom prst="flowChartTerminator">
            <a:avLst/>
          </a:prstGeom>
          <a:noFill/>
          <a:ln w="28575">
            <a:solidFill>
              <a:srgbClr val="2E75B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rgbClr val="052F66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tches :  3.2, 3.4, 3.6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rgbClr val="052F66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D : Wet Drying 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rgbClr val="052F6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 °C / 60% RH / 1h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sz="1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 °C / 30% RH / 4h</a:t>
            </a:r>
          </a:p>
        </p:txBody>
      </p:sp>
    </p:spTree>
    <p:extLst>
      <p:ext uri="{BB962C8B-B14F-4D97-AF65-F5344CB8AC3E}">
        <p14:creationId xmlns:p14="http://schemas.microsoft.com/office/powerpoint/2010/main" val="18551575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Espace réservé du numéro de diapositive 64">
            <a:extLst>
              <a:ext uri="{FF2B5EF4-FFF2-40B4-BE49-F238E27FC236}">
                <a16:creationId xmlns:a16="http://schemas.microsoft.com/office/drawing/2014/main" id="{151542E5-0AD7-4A18-A166-196916DA4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8194A-2738-4764-96E9-C9EC21881488}" type="slidenum">
              <a:rPr lang="fr-FR" smtClean="0"/>
              <a:t>2</a:t>
            </a:fld>
            <a:endParaRPr lang="fr-FR"/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A386CAF8-4CBB-49E4-AED1-DEDF73C8CADD}"/>
              </a:ext>
            </a:extLst>
          </p:cNvPr>
          <p:cNvSpPr/>
          <p:nvPr/>
        </p:nvSpPr>
        <p:spPr>
          <a:xfrm>
            <a:off x="510303" y="287772"/>
            <a:ext cx="6180908" cy="2766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-section (b) </a:t>
            </a:r>
            <a:r>
              <a:rPr lang="fr-FR" sz="1200">
                <a:latin typeface="Times New Roman" panose="02020603050405020304" pitchFamily="18" charset="0"/>
                <a:cs typeface="Times New Roman" panose="02020603050405020304" pitchFamily="18" charset="0"/>
              </a:rPr>
              <a:t>illustratio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experimental dryer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84E972C-C6A2-4211-9462-A4DB60501D27}"/>
              </a:ext>
            </a:extLst>
          </p:cNvPr>
          <p:cNvSpPr/>
          <p:nvPr/>
        </p:nvSpPr>
        <p:spPr>
          <a:xfrm>
            <a:off x="1804729" y="1124943"/>
            <a:ext cx="3561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fr-FR" sz="1200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EF7A3F0-7921-42C5-8582-1EC550DC9C3B}"/>
              </a:ext>
            </a:extLst>
          </p:cNvPr>
          <p:cNvSpPr/>
          <p:nvPr/>
        </p:nvSpPr>
        <p:spPr>
          <a:xfrm>
            <a:off x="7721363" y="1161443"/>
            <a:ext cx="3642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fr-FR" sz="1200" dirty="0"/>
          </a:p>
        </p:txBody>
      </p:sp>
      <p:pic>
        <p:nvPicPr>
          <p:cNvPr id="92" name="Image 91">
            <a:extLst>
              <a:ext uri="{FF2B5EF4-FFF2-40B4-BE49-F238E27FC236}">
                <a16:creationId xmlns:a16="http://schemas.microsoft.com/office/drawing/2014/main" id="{C8B6F3ED-66C6-432D-8B2C-DB85BE18F4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736" y="1962500"/>
            <a:ext cx="3879119" cy="2622199"/>
          </a:xfrm>
          <a:prstGeom prst="rect">
            <a:avLst/>
          </a:prstGeom>
        </p:spPr>
      </p:pic>
      <p:grpSp>
        <p:nvGrpSpPr>
          <p:cNvPr id="119" name="Groupe 118">
            <a:extLst>
              <a:ext uri="{FF2B5EF4-FFF2-40B4-BE49-F238E27FC236}">
                <a16:creationId xmlns:a16="http://schemas.microsoft.com/office/drawing/2014/main" id="{6113803A-0B35-4513-8826-7DAF757ED06E}"/>
              </a:ext>
            </a:extLst>
          </p:cNvPr>
          <p:cNvGrpSpPr/>
          <p:nvPr/>
        </p:nvGrpSpPr>
        <p:grpSpPr>
          <a:xfrm>
            <a:off x="4772488" y="1886839"/>
            <a:ext cx="6998760" cy="4469511"/>
            <a:chOff x="183012" y="152045"/>
            <a:chExt cx="11042651" cy="7051999"/>
          </a:xfrm>
        </p:grpSpPr>
        <p:sp>
          <p:nvSpPr>
            <p:cNvPr id="8" name="Forme libre : forme 7">
              <a:extLst>
                <a:ext uri="{FF2B5EF4-FFF2-40B4-BE49-F238E27FC236}">
                  <a16:creationId xmlns:a16="http://schemas.microsoft.com/office/drawing/2014/main" id="{BAA57DA3-EFC4-4FB5-9F61-2CDE9FF38469}"/>
                </a:ext>
              </a:extLst>
            </p:cNvPr>
            <p:cNvSpPr/>
            <p:nvPr/>
          </p:nvSpPr>
          <p:spPr>
            <a:xfrm>
              <a:off x="3284913" y="1562237"/>
              <a:ext cx="750626" cy="2565779"/>
            </a:xfrm>
            <a:custGeom>
              <a:avLst/>
              <a:gdLst>
                <a:gd name="connsiteX0" fmla="*/ 40943 w 750626"/>
                <a:gd name="connsiteY0" fmla="*/ 330958 h 2565779"/>
                <a:gd name="connsiteX1" fmla="*/ 156949 w 750626"/>
                <a:gd name="connsiteY1" fmla="*/ 262719 h 2565779"/>
                <a:gd name="connsiteX2" fmla="*/ 337782 w 750626"/>
                <a:gd name="connsiteY2" fmla="*/ 163773 h 2565779"/>
                <a:gd name="connsiteX3" fmla="*/ 450376 w 750626"/>
                <a:gd name="connsiteY3" fmla="*/ 112594 h 2565779"/>
                <a:gd name="connsiteX4" fmla="*/ 535674 w 750626"/>
                <a:gd name="connsiteY4" fmla="*/ 75062 h 2565779"/>
                <a:gd name="connsiteX5" fmla="*/ 597089 w 750626"/>
                <a:gd name="connsiteY5" fmla="*/ 58003 h 2565779"/>
                <a:gd name="connsiteX6" fmla="*/ 685800 w 750626"/>
                <a:gd name="connsiteY6" fmla="*/ 27295 h 2565779"/>
                <a:gd name="connsiteX7" fmla="*/ 706271 w 750626"/>
                <a:gd name="connsiteY7" fmla="*/ 20471 h 2565779"/>
                <a:gd name="connsiteX8" fmla="*/ 750626 w 750626"/>
                <a:gd name="connsiteY8" fmla="*/ 0 h 2565779"/>
                <a:gd name="connsiteX9" fmla="*/ 723331 w 750626"/>
                <a:gd name="connsiteY9" fmla="*/ 2548719 h 2565779"/>
                <a:gd name="connsiteX10" fmla="*/ 665328 w 750626"/>
                <a:gd name="connsiteY10" fmla="*/ 2565779 h 2565779"/>
                <a:gd name="connsiteX11" fmla="*/ 0 w 750626"/>
                <a:gd name="connsiteY11" fmla="*/ 2326943 h 2565779"/>
                <a:gd name="connsiteX12" fmla="*/ 40943 w 750626"/>
                <a:gd name="connsiteY12" fmla="*/ 330958 h 2565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750626" h="2565779">
                  <a:moveTo>
                    <a:pt x="40943" y="330958"/>
                  </a:moveTo>
                  <a:lnTo>
                    <a:pt x="156949" y="262719"/>
                  </a:lnTo>
                  <a:lnTo>
                    <a:pt x="337782" y="163773"/>
                  </a:lnTo>
                  <a:lnTo>
                    <a:pt x="450376" y="112594"/>
                  </a:lnTo>
                  <a:lnTo>
                    <a:pt x="535674" y="75062"/>
                  </a:lnTo>
                  <a:lnTo>
                    <a:pt x="597089" y="58003"/>
                  </a:lnTo>
                  <a:lnTo>
                    <a:pt x="685800" y="27295"/>
                  </a:lnTo>
                  <a:lnTo>
                    <a:pt x="706271" y="20471"/>
                  </a:lnTo>
                  <a:lnTo>
                    <a:pt x="750626" y="0"/>
                  </a:lnTo>
                  <a:lnTo>
                    <a:pt x="723331" y="2548719"/>
                  </a:lnTo>
                  <a:lnTo>
                    <a:pt x="665328" y="2565779"/>
                  </a:lnTo>
                  <a:lnTo>
                    <a:pt x="0" y="2326943"/>
                  </a:lnTo>
                  <a:lnTo>
                    <a:pt x="40943" y="330958"/>
                  </a:lnTo>
                  <a:close/>
                </a:path>
              </a:pathLst>
            </a:custGeom>
            <a:pattFill prst="sphere">
              <a:fgClr>
                <a:schemeClr val="accent1"/>
              </a:fgClr>
              <a:bgClr>
                <a:srgbClr val="3CE4FF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Connecteur droit 8">
              <a:extLst>
                <a:ext uri="{FF2B5EF4-FFF2-40B4-BE49-F238E27FC236}">
                  <a16:creationId xmlns:a16="http://schemas.microsoft.com/office/drawing/2014/main" id="{F8074656-3BED-4346-B0B0-51B90FAB4E85}"/>
                </a:ext>
              </a:extLst>
            </p:cNvPr>
            <p:cNvCxnSpPr>
              <a:stCxn id="8" idx="10"/>
              <a:endCxn id="8" idx="6"/>
            </p:cNvCxnSpPr>
            <p:nvPr/>
          </p:nvCxnSpPr>
          <p:spPr>
            <a:xfrm flipV="1">
              <a:off x="3950241" y="1589532"/>
              <a:ext cx="20472" cy="253848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Forme libre : forme 9">
              <a:extLst>
                <a:ext uri="{FF2B5EF4-FFF2-40B4-BE49-F238E27FC236}">
                  <a16:creationId xmlns:a16="http://schemas.microsoft.com/office/drawing/2014/main" id="{614C7897-D395-46C3-8B7B-382EC0D2E345}"/>
                </a:ext>
              </a:extLst>
            </p:cNvPr>
            <p:cNvSpPr/>
            <p:nvPr/>
          </p:nvSpPr>
          <p:spPr>
            <a:xfrm>
              <a:off x="6907757" y="880482"/>
              <a:ext cx="58003" cy="2572603"/>
            </a:xfrm>
            <a:custGeom>
              <a:avLst/>
              <a:gdLst>
                <a:gd name="connsiteX0" fmla="*/ 58003 w 58003"/>
                <a:gd name="connsiteY0" fmla="*/ 0 h 2572603"/>
                <a:gd name="connsiteX1" fmla="*/ 58003 w 58003"/>
                <a:gd name="connsiteY1" fmla="*/ 2569191 h 2572603"/>
                <a:gd name="connsiteX2" fmla="*/ 13648 w 58003"/>
                <a:gd name="connsiteY2" fmla="*/ 2572603 h 2572603"/>
                <a:gd name="connsiteX3" fmla="*/ 0 w 58003"/>
                <a:gd name="connsiteY3" fmla="*/ 13648 h 2572603"/>
                <a:gd name="connsiteX4" fmla="*/ 58003 w 58003"/>
                <a:gd name="connsiteY4" fmla="*/ 0 h 25726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8003" h="2572603">
                  <a:moveTo>
                    <a:pt x="58003" y="0"/>
                  </a:moveTo>
                  <a:lnTo>
                    <a:pt x="58003" y="2569191"/>
                  </a:lnTo>
                  <a:lnTo>
                    <a:pt x="13648" y="2572603"/>
                  </a:lnTo>
                  <a:cubicBezTo>
                    <a:pt x="9099" y="1719618"/>
                    <a:pt x="4549" y="866633"/>
                    <a:pt x="0" y="13648"/>
                  </a:cubicBezTo>
                  <a:lnTo>
                    <a:pt x="58003" y="0"/>
                  </a:lnTo>
                  <a:close/>
                </a:path>
              </a:pathLst>
            </a:custGeom>
            <a:pattFill prst="sphere">
              <a:fgClr>
                <a:schemeClr val="accent1"/>
              </a:fgClr>
              <a:bgClr>
                <a:srgbClr val="3CE4FF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" name="Groupe 10">
              <a:extLst>
                <a:ext uri="{FF2B5EF4-FFF2-40B4-BE49-F238E27FC236}">
                  <a16:creationId xmlns:a16="http://schemas.microsoft.com/office/drawing/2014/main" id="{21D647B6-3556-45C7-BA69-80131CBB0797}"/>
                </a:ext>
              </a:extLst>
            </p:cNvPr>
            <p:cNvGrpSpPr/>
            <p:nvPr/>
          </p:nvGrpSpPr>
          <p:grpSpPr>
            <a:xfrm>
              <a:off x="1100903" y="360814"/>
              <a:ext cx="8028264" cy="6384022"/>
              <a:chOff x="1996253" y="236989"/>
              <a:chExt cx="8028264" cy="6384022"/>
            </a:xfrm>
          </p:grpSpPr>
          <p:pic>
            <p:nvPicPr>
              <p:cNvPr id="12" name="Image 11">
                <a:extLst>
                  <a:ext uri="{FF2B5EF4-FFF2-40B4-BE49-F238E27FC236}">
                    <a16:creationId xmlns:a16="http://schemas.microsoft.com/office/drawing/2014/main" id="{66F3A00B-8DE4-4381-9FB9-4D509DD590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45" t="3670" r="1498" b="3241"/>
              <a:stretch/>
            </p:blipFill>
            <p:spPr>
              <a:xfrm>
                <a:off x="1996253" y="236989"/>
                <a:ext cx="8028264" cy="6384022"/>
              </a:xfrm>
              <a:prstGeom prst="rect">
                <a:avLst/>
              </a:prstGeom>
            </p:spPr>
          </p:pic>
          <p:sp>
            <p:nvSpPr>
              <p:cNvPr id="13" name="Forme libre : forme 12">
                <a:extLst>
                  <a:ext uri="{FF2B5EF4-FFF2-40B4-BE49-F238E27FC236}">
                    <a16:creationId xmlns:a16="http://schemas.microsoft.com/office/drawing/2014/main" id="{4C1721BA-8EEE-440B-875B-5779BA79E422}"/>
                  </a:ext>
                </a:extLst>
              </p:cNvPr>
              <p:cNvSpPr/>
              <p:nvPr/>
            </p:nvSpPr>
            <p:spPr>
              <a:xfrm>
                <a:off x="5064981" y="3968510"/>
                <a:ext cx="874643" cy="2019631"/>
              </a:xfrm>
              <a:custGeom>
                <a:avLst/>
                <a:gdLst>
                  <a:gd name="connsiteX0" fmla="*/ 333955 w 874643"/>
                  <a:gd name="connsiteY0" fmla="*/ 127220 h 2019631"/>
                  <a:gd name="connsiteX1" fmla="*/ 874643 w 874643"/>
                  <a:gd name="connsiteY1" fmla="*/ 0 h 2019631"/>
                  <a:gd name="connsiteX2" fmla="*/ 874643 w 874643"/>
                  <a:gd name="connsiteY2" fmla="*/ 1971923 h 2019631"/>
                  <a:gd name="connsiteX3" fmla="*/ 620202 w 874643"/>
                  <a:gd name="connsiteY3" fmla="*/ 2019631 h 2019631"/>
                  <a:gd name="connsiteX4" fmla="*/ 0 w 874643"/>
                  <a:gd name="connsiteY4" fmla="*/ 1781092 h 2019631"/>
                  <a:gd name="connsiteX5" fmla="*/ 0 w 874643"/>
                  <a:gd name="connsiteY5" fmla="*/ 198782 h 2019631"/>
                  <a:gd name="connsiteX6" fmla="*/ 858741 w 874643"/>
                  <a:gd name="connsiteY6" fmla="*/ 7951 h 2019631"/>
                  <a:gd name="connsiteX7" fmla="*/ 858741 w 874643"/>
                  <a:gd name="connsiteY7" fmla="*/ 7951 h 20196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874643" h="2019631">
                    <a:moveTo>
                      <a:pt x="333955" y="127220"/>
                    </a:moveTo>
                    <a:lnTo>
                      <a:pt x="874643" y="0"/>
                    </a:lnTo>
                    <a:lnTo>
                      <a:pt x="874643" y="1971923"/>
                    </a:lnTo>
                    <a:lnTo>
                      <a:pt x="620202" y="2019631"/>
                    </a:lnTo>
                    <a:lnTo>
                      <a:pt x="0" y="1781092"/>
                    </a:lnTo>
                    <a:lnTo>
                      <a:pt x="0" y="198782"/>
                    </a:lnTo>
                    <a:lnTo>
                      <a:pt x="858741" y="7951"/>
                    </a:lnTo>
                    <a:lnTo>
                      <a:pt x="858741" y="7951"/>
                    </a:lnTo>
                  </a:path>
                </a:pathLst>
              </a:cu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" name="Connecteur droit 13">
                <a:extLst>
                  <a:ext uri="{FF2B5EF4-FFF2-40B4-BE49-F238E27FC236}">
                    <a16:creationId xmlns:a16="http://schemas.microsoft.com/office/drawing/2014/main" id="{C21F4383-F105-41F2-BEF8-CAEF76677C97}"/>
                  </a:ext>
                </a:extLst>
              </p:cNvPr>
              <p:cNvCxnSpPr>
                <a:stCxn id="13" idx="3"/>
              </p:cNvCxnSpPr>
              <p:nvPr/>
            </p:nvCxnSpPr>
            <p:spPr>
              <a:xfrm flipV="1">
                <a:off x="5685183" y="4004191"/>
                <a:ext cx="7951" cy="198395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" name="Groupe 14">
                <a:extLst>
                  <a:ext uri="{FF2B5EF4-FFF2-40B4-BE49-F238E27FC236}">
                    <a16:creationId xmlns:a16="http://schemas.microsoft.com/office/drawing/2014/main" id="{FD98EF7C-8A7A-4691-A7E1-DFB8CE11EFF8}"/>
                  </a:ext>
                </a:extLst>
              </p:cNvPr>
              <p:cNvGrpSpPr/>
              <p:nvPr/>
            </p:nvGrpSpPr>
            <p:grpSpPr>
              <a:xfrm>
                <a:off x="5064981" y="5417757"/>
                <a:ext cx="615312" cy="385738"/>
                <a:chOff x="6893781" y="7786437"/>
                <a:chExt cx="615312" cy="385738"/>
              </a:xfrm>
            </p:grpSpPr>
            <p:cxnSp>
              <p:nvCxnSpPr>
                <p:cNvPr id="52" name="Connecteur droit 51">
                  <a:extLst>
                    <a:ext uri="{FF2B5EF4-FFF2-40B4-BE49-F238E27FC236}">
                      <a16:creationId xmlns:a16="http://schemas.microsoft.com/office/drawing/2014/main" id="{6175071A-A9A4-416F-B70C-CF02E28EF496}"/>
                    </a:ext>
                  </a:extLst>
                </p:cNvPr>
                <p:cNvCxnSpPr>
                  <a:cxnSpLocks/>
                  <a:endCxn id="54" idx="2"/>
                </p:cNvCxnSpPr>
                <p:nvPr/>
              </p:nvCxnSpPr>
              <p:spPr>
                <a:xfrm>
                  <a:off x="6904274" y="7981343"/>
                  <a:ext cx="521069" cy="185459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Connecteur droit 52">
                  <a:extLst>
                    <a:ext uri="{FF2B5EF4-FFF2-40B4-BE49-F238E27FC236}">
                      <a16:creationId xmlns:a16="http://schemas.microsoft.com/office/drawing/2014/main" id="{D32A22B7-0C93-47F6-A787-95AED9202E70}"/>
                    </a:ext>
                  </a:extLst>
                </p:cNvPr>
                <p:cNvCxnSpPr>
                  <a:cxnSpLocks/>
                  <a:endCxn id="54" idx="0"/>
                </p:cNvCxnSpPr>
                <p:nvPr/>
              </p:nvCxnSpPr>
              <p:spPr>
                <a:xfrm>
                  <a:off x="6893781" y="7786437"/>
                  <a:ext cx="562169" cy="19205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" name="Arc 53">
                  <a:extLst>
                    <a:ext uri="{FF2B5EF4-FFF2-40B4-BE49-F238E27FC236}">
                      <a16:creationId xmlns:a16="http://schemas.microsoft.com/office/drawing/2014/main" id="{D88033A3-9462-4600-BCD6-65410E7757FB}"/>
                    </a:ext>
                  </a:extLst>
                </p:cNvPr>
                <p:cNvSpPr/>
                <p:nvPr/>
              </p:nvSpPr>
              <p:spPr>
                <a:xfrm>
                  <a:off x="7382912" y="7977268"/>
                  <a:ext cx="126181" cy="194907"/>
                </a:xfrm>
                <a:prstGeom prst="arc">
                  <a:avLst>
                    <a:gd name="adj1" fmla="val 16554097"/>
                    <a:gd name="adj2" fmla="val 6158723"/>
                  </a:avLst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6" name="Groupe 15">
                <a:extLst>
                  <a:ext uri="{FF2B5EF4-FFF2-40B4-BE49-F238E27FC236}">
                    <a16:creationId xmlns:a16="http://schemas.microsoft.com/office/drawing/2014/main" id="{6D85C035-C87F-40D5-8977-989C234057A8}"/>
                  </a:ext>
                </a:extLst>
              </p:cNvPr>
              <p:cNvGrpSpPr/>
              <p:nvPr/>
            </p:nvGrpSpPr>
            <p:grpSpPr>
              <a:xfrm>
                <a:off x="5059267" y="5033887"/>
                <a:ext cx="615312" cy="385738"/>
                <a:chOff x="6893781" y="7786437"/>
                <a:chExt cx="615312" cy="385738"/>
              </a:xfrm>
            </p:grpSpPr>
            <p:cxnSp>
              <p:nvCxnSpPr>
                <p:cNvPr id="49" name="Connecteur droit 48">
                  <a:extLst>
                    <a:ext uri="{FF2B5EF4-FFF2-40B4-BE49-F238E27FC236}">
                      <a16:creationId xmlns:a16="http://schemas.microsoft.com/office/drawing/2014/main" id="{B9CAB206-4E4C-47F0-8A6F-E0A511951827}"/>
                    </a:ext>
                  </a:extLst>
                </p:cNvPr>
                <p:cNvCxnSpPr>
                  <a:cxnSpLocks/>
                  <a:endCxn id="51" idx="2"/>
                </p:cNvCxnSpPr>
                <p:nvPr/>
              </p:nvCxnSpPr>
              <p:spPr>
                <a:xfrm>
                  <a:off x="6904274" y="7981343"/>
                  <a:ext cx="521069" cy="185459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Connecteur droit 49">
                  <a:extLst>
                    <a:ext uri="{FF2B5EF4-FFF2-40B4-BE49-F238E27FC236}">
                      <a16:creationId xmlns:a16="http://schemas.microsoft.com/office/drawing/2014/main" id="{06BD16ED-0E79-427B-A78B-5DEA56E91A64}"/>
                    </a:ext>
                  </a:extLst>
                </p:cNvPr>
                <p:cNvCxnSpPr>
                  <a:cxnSpLocks/>
                  <a:endCxn id="51" idx="0"/>
                </p:cNvCxnSpPr>
                <p:nvPr/>
              </p:nvCxnSpPr>
              <p:spPr>
                <a:xfrm>
                  <a:off x="6893781" y="7786437"/>
                  <a:ext cx="562169" cy="19205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Arc 50">
                  <a:extLst>
                    <a:ext uri="{FF2B5EF4-FFF2-40B4-BE49-F238E27FC236}">
                      <a16:creationId xmlns:a16="http://schemas.microsoft.com/office/drawing/2014/main" id="{F52DA01C-69A7-49B8-80C3-EBBD75384E2D}"/>
                    </a:ext>
                  </a:extLst>
                </p:cNvPr>
                <p:cNvSpPr/>
                <p:nvPr/>
              </p:nvSpPr>
              <p:spPr>
                <a:xfrm>
                  <a:off x="7382912" y="7977268"/>
                  <a:ext cx="126181" cy="194907"/>
                </a:xfrm>
                <a:prstGeom prst="arc">
                  <a:avLst>
                    <a:gd name="adj1" fmla="val 16554097"/>
                    <a:gd name="adj2" fmla="val 6158723"/>
                  </a:avLst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7" name="Groupe 16">
                <a:extLst>
                  <a:ext uri="{FF2B5EF4-FFF2-40B4-BE49-F238E27FC236}">
                    <a16:creationId xmlns:a16="http://schemas.microsoft.com/office/drawing/2014/main" id="{6FB732C8-FCB5-4682-B8C7-5B6FD5CB8397}"/>
                  </a:ext>
                </a:extLst>
              </p:cNvPr>
              <p:cNvGrpSpPr/>
              <p:nvPr/>
            </p:nvGrpSpPr>
            <p:grpSpPr>
              <a:xfrm>
                <a:off x="5064360" y="4640895"/>
                <a:ext cx="615312" cy="385738"/>
                <a:chOff x="6893781" y="7786437"/>
                <a:chExt cx="615312" cy="385738"/>
              </a:xfrm>
            </p:grpSpPr>
            <p:cxnSp>
              <p:nvCxnSpPr>
                <p:cNvPr id="46" name="Connecteur droit 45">
                  <a:extLst>
                    <a:ext uri="{FF2B5EF4-FFF2-40B4-BE49-F238E27FC236}">
                      <a16:creationId xmlns:a16="http://schemas.microsoft.com/office/drawing/2014/main" id="{403DF210-DD1A-4F0A-9BA0-BDF991407556}"/>
                    </a:ext>
                  </a:extLst>
                </p:cNvPr>
                <p:cNvCxnSpPr>
                  <a:cxnSpLocks/>
                  <a:endCxn id="48" idx="2"/>
                </p:cNvCxnSpPr>
                <p:nvPr/>
              </p:nvCxnSpPr>
              <p:spPr>
                <a:xfrm>
                  <a:off x="6904274" y="7981343"/>
                  <a:ext cx="521069" cy="185459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Connecteur droit 46">
                  <a:extLst>
                    <a:ext uri="{FF2B5EF4-FFF2-40B4-BE49-F238E27FC236}">
                      <a16:creationId xmlns:a16="http://schemas.microsoft.com/office/drawing/2014/main" id="{898DB6E0-31B2-4E89-A771-746CD86DF2CA}"/>
                    </a:ext>
                  </a:extLst>
                </p:cNvPr>
                <p:cNvCxnSpPr>
                  <a:cxnSpLocks/>
                  <a:endCxn id="48" idx="0"/>
                </p:cNvCxnSpPr>
                <p:nvPr/>
              </p:nvCxnSpPr>
              <p:spPr>
                <a:xfrm>
                  <a:off x="6893781" y="7786437"/>
                  <a:ext cx="562169" cy="19205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Arc 47">
                  <a:extLst>
                    <a:ext uri="{FF2B5EF4-FFF2-40B4-BE49-F238E27FC236}">
                      <a16:creationId xmlns:a16="http://schemas.microsoft.com/office/drawing/2014/main" id="{2E93488C-DE29-440D-B270-A9DDA760A458}"/>
                    </a:ext>
                  </a:extLst>
                </p:cNvPr>
                <p:cNvSpPr/>
                <p:nvPr/>
              </p:nvSpPr>
              <p:spPr>
                <a:xfrm>
                  <a:off x="7382912" y="7977268"/>
                  <a:ext cx="126181" cy="194907"/>
                </a:xfrm>
                <a:prstGeom prst="arc">
                  <a:avLst>
                    <a:gd name="adj1" fmla="val 16554097"/>
                    <a:gd name="adj2" fmla="val 6158723"/>
                  </a:avLst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8" name="Groupe 17">
                <a:extLst>
                  <a:ext uri="{FF2B5EF4-FFF2-40B4-BE49-F238E27FC236}">
                    <a16:creationId xmlns:a16="http://schemas.microsoft.com/office/drawing/2014/main" id="{F9F2D391-8E6D-4747-AD99-D50F5DF1697B}"/>
                  </a:ext>
                </a:extLst>
              </p:cNvPr>
              <p:cNvGrpSpPr/>
              <p:nvPr/>
            </p:nvGrpSpPr>
            <p:grpSpPr>
              <a:xfrm>
                <a:off x="5064360" y="4250554"/>
                <a:ext cx="615312" cy="385738"/>
                <a:chOff x="6893781" y="7786437"/>
                <a:chExt cx="615312" cy="385738"/>
              </a:xfrm>
            </p:grpSpPr>
            <p:cxnSp>
              <p:nvCxnSpPr>
                <p:cNvPr id="43" name="Connecteur droit 42">
                  <a:extLst>
                    <a:ext uri="{FF2B5EF4-FFF2-40B4-BE49-F238E27FC236}">
                      <a16:creationId xmlns:a16="http://schemas.microsoft.com/office/drawing/2014/main" id="{22969BB9-9B04-481A-B441-4350568E0B6A}"/>
                    </a:ext>
                  </a:extLst>
                </p:cNvPr>
                <p:cNvCxnSpPr>
                  <a:cxnSpLocks/>
                  <a:endCxn id="45" idx="2"/>
                </p:cNvCxnSpPr>
                <p:nvPr/>
              </p:nvCxnSpPr>
              <p:spPr>
                <a:xfrm>
                  <a:off x="6904274" y="7981343"/>
                  <a:ext cx="521069" cy="185459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Connecteur droit 43">
                  <a:extLst>
                    <a:ext uri="{FF2B5EF4-FFF2-40B4-BE49-F238E27FC236}">
                      <a16:creationId xmlns:a16="http://schemas.microsoft.com/office/drawing/2014/main" id="{2B70D000-98E7-4936-B67C-ADF9E415661E}"/>
                    </a:ext>
                  </a:extLst>
                </p:cNvPr>
                <p:cNvCxnSpPr>
                  <a:cxnSpLocks/>
                  <a:endCxn id="45" idx="0"/>
                </p:cNvCxnSpPr>
                <p:nvPr/>
              </p:nvCxnSpPr>
              <p:spPr>
                <a:xfrm>
                  <a:off x="6893781" y="7786437"/>
                  <a:ext cx="562169" cy="19205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Arc 44">
                  <a:extLst>
                    <a:ext uri="{FF2B5EF4-FFF2-40B4-BE49-F238E27FC236}">
                      <a16:creationId xmlns:a16="http://schemas.microsoft.com/office/drawing/2014/main" id="{B320C34A-93D0-45CF-9EEA-3AA450F4C30D}"/>
                    </a:ext>
                  </a:extLst>
                </p:cNvPr>
                <p:cNvSpPr/>
                <p:nvPr/>
              </p:nvSpPr>
              <p:spPr>
                <a:xfrm>
                  <a:off x="7382912" y="7977268"/>
                  <a:ext cx="126181" cy="194907"/>
                </a:xfrm>
                <a:prstGeom prst="arc">
                  <a:avLst>
                    <a:gd name="adj1" fmla="val 16554097"/>
                    <a:gd name="adj2" fmla="val 6158723"/>
                  </a:avLst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9" name="Groupe 18">
                <a:extLst>
                  <a:ext uri="{FF2B5EF4-FFF2-40B4-BE49-F238E27FC236}">
                    <a16:creationId xmlns:a16="http://schemas.microsoft.com/office/drawing/2014/main" id="{015F9B38-3604-4523-B385-7F6477F63EF9}"/>
                  </a:ext>
                </a:extLst>
              </p:cNvPr>
              <p:cNvGrpSpPr/>
              <p:nvPr/>
            </p:nvGrpSpPr>
            <p:grpSpPr>
              <a:xfrm>
                <a:off x="5173936" y="4057530"/>
                <a:ext cx="505736" cy="232662"/>
                <a:chOff x="7003357" y="7939513"/>
                <a:chExt cx="505736" cy="232662"/>
              </a:xfrm>
            </p:grpSpPr>
            <p:cxnSp>
              <p:nvCxnSpPr>
                <p:cNvPr id="40" name="Connecteur droit 39">
                  <a:extLst>
                    <a:ext uri="{FF2B5EF4-FFF2-40B4-BE49-F238E27FC236}">
                      <a16:creationId xmlns:a16="http://schemas.microsoft.com/office/drawing/2014/main" id="{14E401C2-3445-4BFB-86C7-043CAC55DF8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03357" y="8020373"/>
                  <a:ext cx="424243" cy="150023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Connecteur droit 40">
                  <a:extLst>
                    <a:ext uri="{FF2B5EF4-FFF2-40B4-BE49-F238E27FC236}">
                      <a16:creationId xmlns:a16="http://schemas.microsoft.com/office/drawing/2014/main" id="{794C7AC6-B820-4B90-A545-869552420135}"/>
                    </a:ext>
                  </a:extLst>
                </p:cNvPr>
                <p:cNvCxnSpPr>
                  <a:cxnSpLocks/>
                  <a:endCxn id="42" idx="0"/>
                </p:cNvCxnSpPr>
                <p:nvPr/>
              </p:nvCxnSpPr>
              <p:spPr>
                <a:xfrm>
                  <a:off x="7343499" y="7939513"/>
                  <a:ext cx="112451" cy="38974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Arc 41">
                  <a:extLst>
                    <a:ext uri="{FF2B5EF4-FFF2-40B4-BE49-F238E27FC236}">
                      <a16:creationId xmlns:a16="http://schemas.microsoft.com/office/drawing/2014/main" id="{B6FDD809-49BF-41F0-B6A5-8634CD150D7C}"/>
                    </a:ext>
                  </a:extLst>
                </p:cNvPr>
                <p:cNvSpPr/>
                <p:nvPr/>
              </p:nvSpPr>
              <p:spPr>
                <a:xfrm>
                  <a:off x="7382912" y="7977268"/>
                  <a:ext cx="126181" cy="194907"/>
                </a:xfrm>
                <a:prstGeom prst="arc">
                  <a:avLst>
                    <a:gd name="adj1" fmla="val 16554097"/>
                    <a:gd name="adj2" fmla="val 6158723"/>
                  </a:avLst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0" name="Groupe 19">
                <a:extLst>
                  <a:ext uri="{FF2B5EF4-FFF2-40B4-BE49-F238E27FC236}">
                    <a16:creationId xmlns:a16="http://schemas.microsoft.com/office/drawing/2014/main" id="{9D4139E2-E437-474B-8214-8F460FEB382F}"/>
                  </a:ext>
                </a:extLst>
              </p:cNvPr>
              <p:cNvGrpSpPr/>
              <p:nvPr/>
            </p:nvGrpSpPr>
            <p:grpSpPr>
              <a:xfrm>
                <a:off x="3627851" y="4695237"/>
                <a:ext cx="843330" cy="588853"/>
                <a:chOff x="3627851" y="4695237"/>
                <a:chExt cx="843330" cy="588853"/>
              </a:xfrm>
            </p:grpSpPr>
            <p:sp>
              <p:nvSpPr>
                <p:cNvPr id="23" name="Ellipse 22">
                  <a:extLst>
                    <a:ext uri="{FF2B5EF4-FFF2-40B4-BE49-F238E27FC236}">
                      <a16:creationId xmlns:a16="http://schemas.microsoft.com/office/drawing/2014/main" id="{E44647CE-4429-4FA8-BCF3-AB9990BC82E9}"/>
                    </a:ext>
                  </a:extLst>
                </p:cNvPr>
                <p:cNvSpPr/>
                <p:nvPr/>
              </p:nvSpPr>
              <p:spPr>
                <a:xfrm>
                  <a:off x="3755610" y="4727565"/>
                  <a:ext cx="176212" cy="173832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24" name="Image 23">
                  <a:extLst>
                    <a:ext uri="{FF2B5EF4-FFF2-40B4-BE49-F238E27FC236}">
                      <a16:creationId xmlns:a16="http://schemas.microsoft.com/office/drawing/2014/main" id="{D7139D75-70A1-4D14-A179-6A6284FBCE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959772" y="4740278"/>
                  <a:ext cx="188992" cy="182896"/>
                </a:xfrm>
                <a:prstGeom prst="rect">
                  <a:avLst/>
                </a:prstGeom>
              </p:spPr>
            </p:pic>
            <p:pic>
              <p:nvPicPr>
                <p:cNvPr id="26" name="Image 25">
                  <a:extLst>
                    <a:ext uri="{FF2B5EF4-FFF2-40B4-BE49-F238E27FC236}">
                      <a16:creationId xmlns:a16="http://schemas.microsoft.com/office/drawing/2014/main" id="{668DFC5E-28F9-4021-838D-25F19D25C8E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876436" y="4695237"/>
                  <a:ext cx="188992" cy="182896"/>
                </a:xfrm>
                <a:prstGeom prst="rect">
                  <a:avLst/>
                </a:prstGeom>
              </p:spPr>
            </p:pic>
            <p:pic>
              <p:nvPicPr>
                <p:cNvPr id="27" name="Image 26">
                  <a:extLst>
                    <a:ext uri="{FF2B5EF4-FFF2-40B4-BE49-F238E27FC236}">
                      <a16:creationId xmlns:a16="http://schemas.microsoft.com/office/drawing/2014/main" id="{DD27D613-47BF-4804-ABF8-74E001B3FAB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644411" y="4831726"/>
                  <a:ext cx="188992" cy="182896"/>
                </a:xfrm>
                <a:prstGeom prst="rect">
                  <a:avLst/>
                </a:prstGeom>
              </p:spPr>
            </p:pic>
            <p:pic>
              <p:nvPicPr>
                <p:cNvPr id="28" name="Image 27">
                  <a:extLst>
                    <a:ext uri="{FF2B5EF4-FFF2-40B4-BE49-F238E27FC236}">
                      <a16:creationId xmlns:a16="http://schemas.microsoft.com/office/drawing/2014/main" id="{9A50CFF4-1CB3-47CF-BFAA-51F1E6E5F7B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642814" y="4853968"/>
                  <a:ext cx="188992" cy="182896"/>
                </a:xfrm>
                <a:prstGeom prst="rect">
                  <a:avLst/>
                </a:prstGeom>
              </p:spPr>
            </p:pic>
            <p:pic>
              <p:nvPicPr>
                <p:cNvPr id="29" name="Image 28">
                  <a:extLst>
                    <a:ext uri="{FF2B5EF4-FFF2-40B4-BE49-F238E27FC236}">
                      <a16:creationId xmlns:a16="http://schemas.microsoft.com/office/drawing/2014/main" id="{B3EC97CB-0FEC-44CC-80CE-CB078252B0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698632" y="5007390"/>
                  <a:ext cx="156287" cy="151246"/>
                </a:xfrm>
                <a:prstGeom prst="rect">
                  <a:avLst/>
                </a:prstGeom>
              </p:spPr>
            </p:pic>
            <p:pic>
              <p:nvPicPr>
                <p:cNvPr id="30" name="Image 29">
                  <a:extLst>
                    <a:ext uri="{FF2B5EF4-FFF2-40B4-BE49-F238E27FC236}">
                      <a16:creationId xmlns:a16="http://schemas.microsoft.com/office/drawing/2014/main" id="{4FE52256-3A21-49F5-AF11-EDED9DB681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780296" y="5069162"/>
                  <a:ext cx="156287" cy="151246"/>
                </a:xfrm>
                <a:prstGeom prst="rect">
                  <a:avLst/>
                </a:prstGeom>
              </p:spPr>
            </p:pic>
            <p:pic>
              <p:nvPicPr>
                <p:cNvPr id="31" name="Image 30">
                  <a:extLst>
                    <a:ext uri="{FF2B5EF4-FFF2-40B4-BE49-F238E27FC236}">
                      <a16:creationId xmlns:a16="http://schemas.microsoft.com/office/drawing/2014/main" id="{0FE4F08A-D9C5-49D3-8735-676093C295E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889171" y="5077547"/>
                  <a:ext cx="156287" cy="151246"/>
                </a:xfrm>
                <a:prstGeom prst="rect">
                  <a:avLst/>
                </a:prstGeom>
              </p:spPr>
            </p:pic>
            <p:pic>
              <p:nvPicPr>
                <p:cNvPr id="32" name="Image 31">
                  <a:extLst>
                    <a:ext uri="{FF2B5EF4-FFF2-40B4-BE49-F238E27FC236}">
                      <a16:creationId xmlns:a16="http://schemas.microsoft.com/office/drawing/2014/main" id="{6886C696-D454-414E-A3C0-14B8C4ACFC3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003240" y="4828019"/>
                  <a:ext cx="156287" cy="151246"/>
                </a:xfrm>
                <a:prstGeom prst="rect">
                  <a:avLst/>
                </a:prstGeom>
              </p:spPr>
            </p:pic>
            <p:pic>
              <p:nvPicPr>
                <p:cNvPr id="33" name="Image 32">
                  <a:extLst>
                    <a:ext uri="{FF2B5EF4-FFF2-40B4-BE49-F238E27FC236}">
                      <a16:creationId xmlns:a16="http://schemas.microsoft.com/office/drawing/2014/main" id="{96910026-483B-4AC6-99C7-65D0CBDD1DA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959603" y="4987047"/>
                  <a:ext cx="156287" cy="151246"/>
                </a:xfrm>
                <a:prstGeom prst="rect">
                  <a:avLst/>
                </a:prstGeom>
              </p:spPr>
            </p:pic>
            <p:pic>
              <p:nvPicPr>
                <p:cNvPr id="34" name="Image 33">
                  <a:extLst>
                    <a:ext uri="{FF2B5EF4-FFF2-40B4-BE49-F238E27FC236}">
                      <a16:creationId xmlns:a16="http://schemas.microsoft.com/office/drawing/2014/main" id="{D880D4F6-4C20-4698-9B56-7C0CE24916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827560" y="4969023"/>
                  <a:ext cx="156287" cy="151246"/>
                </a:xfrm>
                <a:prstGeom prst="rect">
                  <a:avLst/>
                </a:prstGeom>
              </p:spPr>
            </p:pic>
            <p:pic>
              <p:nvPicPr>
                <p:cNvPr id="35" name="Image 34">
                  <a:extLst>
                    <a:ext uri="{FF2B5EF4-FFF2-40B4-BE49-F238E27FC236}">
                      <a16:creationId xmlns:a16="http://schemas.microsoft.com/office/drawing/2014/main" id="{DB78D68C-FBE3-4873-A43F-FB71193445D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754461" y="4902500"/>
                  <a:ext cx="156287" cy="151246"/>
                </a:xfrm>
                <a:prstGeom prst="rect">
                  <a:avLst/>
                </a:prstGeom>
              </p:spPr>
            </p:pic>
            <p:pic>
              <p:nvPicPr>
                <p:cNvPr id="36" name="Image 35">
                  <a:extLst>
                    <a:ext uri="{FF2B5EF4-FFF2-40B4-BE49-F238E27FC236}">
                      <a16:creationId xmlns:a16="http://schemas.microsoft.com/office/drawing/2014/main" id="{6BE9CF0F-7538-41D1-BBF4-C7CB6F4B50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836696" y="4831777"/>
                  <a:ext cx="156287" cy="151246"/>
                </a:xfrm>
                <a:prstGeom prst="rect">
                  <a:avLst/>
                </a:prstGeom>
              </p:spPr>
            </p:pic>
            <p:pic>
              <p:nvPicPr>
                <p:cNvPr id="37" name="Image 36">
                  <a:extLst>
                    <a:ext uri="{FF2B5EF4-FFF2-40B4-BE49-F238E27FC236}">
                      <a16:creationId xmlns:a16="http://schemas.microsoft.com/office/drawing/2014/main" id="{6B53807F-5EA5-460E-8BDE-FAA06965390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899851" y="4879423"/>
                  <a:ext cx="156287" cy="151246"/>
                </a:xfrm>
                <a:prstGeom prst="rect">
                  <a:avLst/>
                </a:prstGeom>
              </p:spPr>
            </p:pic>
            <p:sp>
              <p:nvSpPr>
                <p:cNvPr id="38" name="Forme libre : forme 37">
                  <a:extLst>
                    <a:ext uri="{FF2B5EF4-FFF2-40B4-BE49-F238E27FC236}">
                      <a16:creationId xmlns:a16="http://schemas.microsoft.com/office/drawing/2014/main" id="{5F57B43C-164C-4204-B4A5-3838409616EE}"/>
                    </a:ext>
                  </a:extLst>
                </p:cNvPr>
                <p:cNvSpPr/>
                <p:nvPr/>
              </p:nvSpPr>
              <p:spPr>
                <a:xfrm>
                  <a:off x="3937183" y="4887764"/>
                  <a:ext cx="506538" cy="256558"/>
                </a:xfrm>
                <a:custGeom>
                  <a:avLst/>
                  <a:gdLst>
                    <a:gd name="connsiteX0" fmla="*/ 39470 w 506538"/>
                    <a:gd name="connsiteY0" fmla="*/ 0 h 256558"/>
                    <a:gd name="connsiteX1" fmla="*/ 210509 w 506538"/>
                    <a:gd name="connsiteY1" fmla="*/ 72363 h 256558"/>
                    <a:gd name="connsiteX2" fmla="*/ 506538 w 506538"/>
                    <a:gd name="connsiteY2" fmla="*/ 187485 h 256558"/>
                    <a:gd name="connsiteX3" fmla="*/ 483513 w 506538"/>
                    <a:gd name="connsiteY3" fmla="*/ 256558 h 256558"/>
                    <a:gd name="connsiteX4" fmla="*/ 0 w 506538"/>
                    <a:gd name="connsiteY4" fmla="*/ 131568 h 256558"/>
                    <a:gd name="connsiteX5" fmla="*/ 39470 w 506538"/>
                    <a:gd name="connsiteY5" fmla="*/ 0 h 25655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506538" h="256558">
                      <a:moveTo>
                        <a:pt x="39470" y="0"/>
                      </a:moveTo>
                      <a:lnTo>
                        <a:pt x="210509" y="72363"/>
                      </a:lnTo>
                      <a:lnTo>
                        <a:pt x="506538" y="187485"/>
                      </a:lnTo>
                      <a:lnTo>
                        <a:pt x="483513" y="256558"/>
                      </a:lnTo>
                      <a:lnTo>
                        <a:pt x="0" y="131568"/>
                      </a:lnTo>
                      <a:lnTo>
                        <a:pt x="39470" y="0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39" name="Image 38">
                  <a:extLst>
                    <a:ext uri="{FF2B5EF4-FFF2-40B4-BE49-F238E27FC236}">
                      <a16:creationId xmlns:a16="http://schemas.microsoft.com/office/drawing/2014/main" id="{0DCB9B55-51CF-4C45-A4B9-636B4D23469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tretch>
                  <a:fillRect/>
                </a:stretch>
              </p:blipFill>
              <p:spPr>
                <a:xfrm rot="17228752">
                  <a:off x="3761592" y="4574501"/>
                  <a:ext cx="575848" cy="843330"/>
                </a:xfrm>
                <a:prstGeom prst="rect">
                  <a:avLst/>
                </a:prstGeom>
              </p:spPr>
            </p:pic>
          </p:grpSp>
          <p:sp>
            <p:nvSpPr>
              <p:cNvPr id="21" name="Flèche : droite 20">
                <a:extLst>
                  <a:ext uri="{FF2B5EF4-FFF2-40B4-BE49-F238E27FC236}">
                    <a16:creationId xmlns:a16="http://schemas.microsoft.com/office/drawing/2014/main" id="{7B60C8AE-50DC-48F9-AF35-97F6375CC504}"/>
                  </a:ext>
                </a:extLst>
              </p:cNvPr>
              <p:cNvSpPr/>
              <p:nvPr/>
            </p:nvSpPr>
            <p:spPr>
              <a:xfrm rot="706478">
                <a:off x="6232046" y="5227361"/>
                <a:ext cx="396737" cy="483071"/>
              </a:xfrm>
              <a:prstGeom prst="rightArrow">
                <a:avLst/>
              </a:prstGeom>
              <a:solidFill>
                <a:srgbClr val="3CE4FF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Flèche : droite 21">
                <a:extLst>
                  <a:ext uri="{FF2B5EF4-FFF2-40B4-BE49-F238E27FC236}">
                    <a16:creationId xmlns:a16="http://schemas.microsoft.com/office/drawing/2014/main" id="{5BB03747-EA81-48E7-B713-E72AE8A0EB3C}"/>
                  </a:ext>
                </a:extLst>
              </p:cNvPr>
              <p:cNvSpPr/>
              <p:nvPr/>
            </p:nvSpPr>
            <p:spPr>
              <a:xfrm rot="11546772">
                <a:off x="6627165" y="5144432"/>
                <a:ext cx="396737" cy="483071"/>
              </a:xfrm>
              <a:prstGeom prst="rightArrow">
                <a:avLst/>
              </a:prstGeom>
              <a:solidFill>
                <a:srgbClr val="0070C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55" name="Connecteur droit 54">
              <a:extLst>
                <a:ext uri="{FF2B5EF4-FFF2-40B4-BE49-F238E27FC236}">
                  <a16:creationId xmlns:a16="http://schemas.microsoft.com/office/drawing/2014/main" id="{2FA20984-E8C8-4B8D-88EE-E2706F9826FB}"/>
                </a:ext>
              </a:extLst>
            </p:cNvPr>
            <p:cNvCxnSpPr>
              <a:cxnSpLocks/>
            </p:cNvCxnSpPr>
            <p:nvPr/>
          </p:nvCxnSpPr>
          <p:spPr>
            <a:xfrm>
              <a:off x="6907757" y="4662014"/>
              <a:ext cx="1299895" cy="439934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689C05CE-A86B-414F-BF0E-E0D655720835}"/>
                </a:ext>
              </a:extLst>
            </p:cNvPr>
            <p:cNvSpPr txBox="1"/>
            <p:nvPr/>
          </p:nvSpPr>
          <p:spPr>
            <a:xfrm>
              <a:off x="8136763" y="5023682"/>
              <a:ext cx="786654" cy="388488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n</a:t>
              </a:r>
            </a:p>
          </p:txBody>
        </p:sp>
        <p:cxnSp>
          <p:nvCxnSpPr>
            <p:cNvPr id="57" name="Connecteur droit 56">
              <a:extLst>
                <a:ext uri="{FF2B5EF4-FFF2-40B4-BE49-F238E27FC236}">
                  <a16:creationId xmlns:a16="http://schemas.microsoft.com/office/drawing/2014/main" id="{6A5E9E76-4917-4BA1-8790-0378E81F1A5D}"/>
                </a:ext>
              </a:extLst>
            </p:cNvPr>
            <p:cNvCxnSpPr>
              <a:cxnSpLocks/>
              <a:endCxn id="59" idx="1"/>
            </p:cNvCxnSpPr>
            <p:nvPr/>
          </p:nvCxnSpPr>
          <p:spPr>
            <a:xfrm>
              <a:off x="5593807" y="5641150"/>
              <a:ext cx="1391908" cy="571035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cteur droit 57">
              <a:extLst>
                <a:ext uri="{FF2B5EF4-FFF2-40B4-BE49-F238E27FC236}">
                  <a16:creationId xmlns:a16="http://schemas.microsoft.com/office/drawing/2014/main" id="{2E15558C-5356-414B-BFA5-5BF0D19F7531}"/>
                </a:ext>
              </a:extLst>
            </p:cNvPr>
            <p:cNvCxnSpPr>
              <a:cxnSpLocks/>
              <a:endCxn id="59" idx="1"/>
            </p:cNvCxnSpPr>
            <p:nvPr/>
          </p:nvCxnSpPr>
          <p:spPr>
            <a:xfrm>
              <a:off x="6001381" y="5526608"/>
              <a:ext cx="984333" cy="685577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8A02C747-DDB3-4C82-982F-A702C219937B}"/>
                </a:ext>
              </a:extLst>
            </p:cNvPr>
            <p:cNvSpPr txBox="1"/>
            <p:nvPr/>
          </p:nvSpPr>
          <p:spPr>
            <a:xfrm>
              <a:off x="6985714" y="5896538"/>
              <a:ext cx="1633542" cy="631294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ir outlet / inlet</a:t>
              </a:r>
            </a:p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 m</a:t>
              </a:r>
              <a:r>
                <a:rPr lang="en-GB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/h</a:t>
              </a:r>
            </a:p>
          </p:txBody>
        </p:sp>
        <p:cxnSp>
          <p:nvCxnSpPr>
            <p:cNvPr id="60" name="Connecteur droit 59">
              <a:extLst>
                <a:ext uri="{FF2B5EF4-FFF2-40B4-BE49-F238E27FC236}">
                  <a16:creationId xmlns:a16="http://schemas.microsoft.com/office/drawing/2014/main" id="{C1E29A88-E214-4841-97E2-7CB0A2A114A6}"/>
                </a:ext>
              </a:extLst>
            </p:cNvPr>
            <p:cNvCxnSpPr>
              <a:cxnSpLocks/>
            </p:cNvCxnSpPr>
            <p:nvPr/>
          </p:nvCxnSpPr>
          <p:spPr>
            <a:xfrm>
              <a:off x="4840804" y="5280118"/>
              <a:ext cx="1089380" cy="1109547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>
              <a:extLst>
                <a:ext uri="{FF2B5EF4-FFF2-40B4-BE49-F238E27FC236}">
                  <a16:creationId xmlns:a16="http://schemas.microsoft.com/office/drawing/2014/main" id="{99C5FC32-2673-4EC1-BE46-0FC5E7AF510F}"/>
                </a:ext>
              </a:extLst>
            </p:cNvPr>
            <p:cNvSpPr txBox="1"/>
            <p:nvPr/>
          </p:nvSpPr>
          <p:spPr>
            <a:xfrm>
              <a:off x="5228282" y="6367824"/>
              <a:ext cx="1594994" cy="631294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ctric heater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 kW</a:t>
              </a:r>
            </a:p>
          </p:txBody>
        </p:sp>
        <p:cxnSp>
          <p:nvCxnSpPr>
            <p:cNvPr id="62" name="Connecteur droit 61">
              <a:extLst>
                <a:ext uri="{FF2B5EF4-FFF2-40B4-BE49-F238E27FC236}">
                  <a16:creationId xmlns:a16="http://schemas.microsoft.com/office/drawing/2014/main" id="{AF803421-7125-4FC0-9D54-E154A9ADDB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96031" y="5265579"/>
              <a:ext cx="6805" cy="1346004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0C0F3851-29A3-473F-B496-DFDCB36CD133}"/>
                </a:ext>
              </a:extLst>
            </p:cNvPr>
            <p:cNvSpPr txBox="1"/>
            <p:nvPr/>
          </p:nvSpPr>
          <p:spPr>
            <a:xfrm>
              <a:off x="2692601" y="6572750"/>
              <a:ext cx="1601801" cy="631294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eam injection</a:t>
              </a:r>
              <a:b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 kg/h</a:t>
              </a:r>
            </a:p>
          </p:txBody>
        </p: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id="{106369B9-11E4-4836-9DC1-6040A9EE3025}"/>
                </a:ext>
              </a:extLst>
            </p:cNvPr>
            <p:cNvSpPr txBox="1"/>
            <p:nvPr/>
          </p:nvSpPr>
          <p:spPr>
            <a:xfrm>
              <a:off x="8557651" y="848613"/>
              <a:ext cx="1303109" cy="388488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neycomb</a:t>
              </a:r>
            </a:p>
          </p:txBody>
        </p:sp>
        <p:cxnSp>
          <p:nvCxnSpPr>
            <p:cNvPr id="66" name="Connecteur droit 65">
              <a:extLst>
                <a:ext uri="{FF2B5EF4-FFF2-40B4-BE49-F238E27FC236}">
                  <a16:creationId xmlns:a16="http://schemas.microsoft.com/office/drawing/2014/main" id="{0872ABB0-9D17-427E-97CE-CE827BE6CA2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99134" y="1050713"/>
              <a:ext cx="1791263" cy="684962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cteur droit 66">
              <a:extLst>
                <a:ext uri="{FF2B5EF4-FFF2-40B4-BE49-F238E27FC236}">
                  <a16:creationId xmlns:a16="http://schemas.microsoft.com/office/drawing/2014/main" id="{2A82A9B5-CFF4-48D0-A990-999540E933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0904" y="3830323"/>
              <a:ext cx="2414950" cy="1939768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cteur droit 67">
              <a:extLst>
                <a:ext uri="{FF2B5EF4-FFF2-40B4-BE49-F238E27FC236}">
                  <a16:creationId xmlns:a16="http://schemas.microsoft.com/office/drawing/2014/main" id="{73D62A6F-B23B-4CB0-9D80-5DDA5D94EA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22793" y="3345119"/>
              <a:ext cx="5842967" cy="2406993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96A31725-698A-4FF1-8154-A6640CD75B19}"/>
                </a:ext>
              </a:extLst>
            </p:cNvPr>
            <p:cNvSpPr/>
            <p:nvPr/>
          </p:nvSpPr>
          <p:spPr>
            <a:xfrm>
              <a:off x="183012" y="5691898"/>
              <a:ext cx="1391531" cy="388488"/>
            </a:xfrm>
            <a:prstGeom prst="rect">
              <a:avLst/>
            </a:prstGeom>
            <a:ln w="28575">
              <a:noFill/>
            </a:ln>
          </p:spPr>
          <p:txBody>
            <a:bodyPr wrap="square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woven</a:t>
              </a:r>
            </a:p>
          </p:txBody>
        </p:sp>
        <p:sp>
          <p:nvSpPr>
            <p:cNvPr id="70" name="Forme libre : forme 69">
              <a:extLst>
                <a:ext uri="{FF2B5EF4-FFF2-40B4-BE49-F238E27FC236}">
                  <a16:creationId xmlns:a16="http://schemas.microsoft.com/office/drawing/2014/main" id="{6CDCD35E-80B7-43FF-9099-04ECA9878F58}"/>
                </a:ext>
              </a:extLst>
            </p:cNvPr>
            <p:cNvSpPr/>
            <p:nvPr/>
          </p:nvSpPr>
          <p:spPr>
            <a:xfrm>
              <a:off x="4146433" y="2749579"/>
              <a:ext cx="2637910" cy="796954"/>
            </a:xfrm>
            <a:custGeom>
              <a:avLst/>
              <a:gdLst>
                <a:gd name="connsiteX0" fmla="*/ 0 w 2600588"/>
                <a:gd name="connsiteY0" fmla="*/ 444617 h 796954"/>
                <a:gd name="connsiteX1" fmla="*/ 1971413 w 2600588"/>
                <a:gd name="connsiteY1" fmla="*/ 0 h 796954"/>
                <a:gd name="connsiteX2" fmla="*/ 2600588 w 2600588"/>
                <a:gd name="connsiteY2" fmla="*/ 201336 h 796954"/>
                <a:gd name="connsiteX3" fmla="*/ 0 w 2600588"/>
                <a:gd name="connsiteY3" fmla="*/ 796954 h 796954"/>
                <a:gd name="connsiteX4" fmla="*/ 0 w 2600588"/>
                <a:gd name="connsiteY4" fmla="*/ 444617 h 796954"/>
                <a:gd name="connsiteX0" fmla="*/ 0 w 2637910"/>
                <a:gd name="connsiteY0" fmla="*/ 444617 h 796954"/>
                <a:gd name="connsiteX1" fmla="*/ 1971413 w 2637910"/>
                <a:gd name="connsiteY1" fmla="*/ 0 h 796954"/>
                <a:gd name="connsiteX2" fmla="*/ 2637910 w 2637910"/>
                <a:gd name="connsiteY2" fmla="*/ 201336 h 796954"/>
                <a:gd name="connsiteX3" fmla="*/ 0 w 2637910"/>
                <a:gd name="connsiteY3" fmla="*/ 796954 h 796954"/>
                <a:gd name="connsiteX4" fmla="*/ 0 w 2637910"/>
                <a:gd name="connsiteY4" fmla="*/ 444617 h 7969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37910" h="796954">
                  <a:moveTo>
                    <a:pt x="0" y="444617"/>
                  </a:moveTo>
                  <a:lnTo>
                    <a:pt x="1971413" y="0"/>
                  </a:lnTo>
                  <a:lnTo>
                    <a:pt x="2637910" y="201336"/>
                  </a:lnTo>
                  <a:lnTo>
                    <a:pt x="0" y="796954"/>
                  </a:lnTo>
                  <a:lnTo>
                    <a:pt x="0" y="444617"/>
                  </a:lnTo>
                  <a:close/>
                </a:path>
              </a:pathLst>
            </a:custGeom>
            <a:pattFill prst="openDmnd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id="{7553F95A-7FF8-4C71-93F9-828CA21AEE1B}"/>
                </a:ext>
              </a:extLst>
            </p:cNvPr>
            <p:cNvSpPr txBox="1"/>
            <p:nvPr/>
          </p:nvSpPr>
          <p:spPr>
            <a:xfrm>
              <a:off x="9439359" y="3749914"/>
              <a:ext cx="1786304" cy="631294"/>
            </a:xfrm>
            <a:prstGeom prst="rect">
              <a:avLst/>
            </a:prstGeom>
            <a:noFill/>
            <a:ln w="2857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 Drying trays</a:t>
              </a:r>
              <a:b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2 x 0.78 m²</a:t>
              </a:r>
            </a:p>
          </p:txBody>
        </p:sp>
        <p:cxnSp>
          <p:nvCxnSpPr>
            <p:cNvPr id="72" name="Connecteur droit 71">
              <a:extLst>
                <a:ext uri="{FF2B5EF4-FFF2-40B4-BE49-F238E27FC236}">
                  <a16:creationId xmlns:a16="http://schemas.microsoft.com/office/drawing/2014/main" id="{B546EEEE-537D-4DC9-9FEF-8A47460DCF77}"/>
                </a:ext>
              </a:extLst>
            </p:cNvPr>
            <p:cNvCxnSpPr>
              <a:cxnSpLocks/>
              <a:endCxn id="71" idx="1"/>
            </p:cNvCxnSpPr>
            <p:nvPr/>
          </p:nvCxnSpPr>
          <p:spPr>
            <a:xfrm>
              <a:off x="5710788" y="3012469"/>
              <a:ext cx="3728571" cy="1053092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Forme libre : forme 72">
              <a:extLst>
                <a:ext uri="{FF2B5EF4-FFF2-40B4-BE49-F238E27FC236}">
                  <a16:creationId xmlns:a16="http://schemas.microsoft.com/office/drawing/2014/main" id="{DD1D73D6-D03B-4B5E-95BD-F988F93F554E}"/>
                </a:ext>
              </a:extLst>
            </p:cNvPr>
            <p:cNvSpPr/>
            <p:nvPr/>
          </p:nvSpPr>
          <p:spPr>
            <a:xfrm>
              <a:off x="4138363" y="1541182"/>
              <a:ext cx="2637911" cy="796954"/>
            </a:xfrm>
            <a:custGeom>
              <a:avLst/>
              <a:gdLst>
                <a:gd name="connsiteX0" fmla="*/ 0 w 2600588"/>
                <a:gd name="connsiteY0" fmla="*/ 444617 h 796954"/>
                <a:gd name="connsiteX1" fmla="*/ 1971413 w 2600588"/>
                <a:gd name="connsiteY1" fmla="*/ 0 h 796954"/>
                <a:gd name="connsiteX2" fmla="*/ 2600588 w 2600588"/>
                <a:gd name="connsiteY2" fmla="*/ 201336 h 796954"/>
                <a:gd name="connsiteX3" fmla="*/ 0 w 2600588"/>
                <a:gd name="connsiteY3" fmla="*/ 796954 h 796954"/>
                <a:gd name="connsiteX4" fmla="*/ 0 w 2600588"/>
                <a:gd name="connsiteY4" fmla="*/ 444617 h 796954"/>
                <a:gd name="connsiteX0" fmla="*/ 0 w 2637911"/>
                <a:gd name="connsiteY0" fmla="*/ 444617 h 796954"/>
                <a:gd name="connsiteX1" fmla="*/ 1971413 w 2637911"/>
                <a:gd name="connsiteY1" fmla="*/ 0 h 796954"/>
                <a:gd name="connsiteX2" fmla="*/ 2637911 w 2637911"/>
                <a:gd name="connsiteY2" fmla="*/ 201336 h 796954"/>
                <a:gd name="connsiteX3" fmla="*/ 0 w 2637911"/>
                <a:gd name="connsiteY3" fmla="*/ 796954 h 796954"/>
                <a:gd name="connsiteX4" fmla="*/ 0 w 2637911"/>
                <a:gd name="connsiteY4" fmla="*/ 444617 h 7969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637911" h="796954">
                  <a:moveTo>
                    <a:pt x="0" y="444617"/>
                  </a:moveTo>
                  <a:lnTo>
                    <a:pt x="1971413" y="0"/>
                  </a:lnTo>
                  <a:lnTo>
                    <a:pt x="2637911" y="201336"/>
                  </a:lnTo>
                  <a:lnTo>
                    <a:pt x="0" y="796954"/>
                  </a:lnTo>
                  <a:lnTo>
                    <a:pt x="0" y="444617"/>
                  </a:lnTo>
                  <a:close/>
                </a:path>
              </a:pathLst>
            </a:custGeom>
            <a:pattFill prst="openDmnd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4" name="Connecteur droit 73">
              <a:extLst>
                <a:ext uri="{FF2B5EF4-FFF2-40B4-BE49-F238E27FC236}">
                  <a16:creationId xmlns:a16="http://schemas.microsoft.com/office/drawing/2014/main" id="{38C209AD-4EC7-445E-A3CC-55C3FE99703E}"/>
                </a:ext>
              </a:extLst>
            </p:cNvPr>
            <p:cNvCxnSpPr>
              <a:cxnSpLocks/>
              <a:endCxn id="71" idx="1"/>
            </p:cNvCxnSpPr>
            <p:nvPr/>
          </p:nvCxnSpPr>
          <p:spPr>
            <a:xfrm>
              <a:off x="5389913" y="1879221"/>
              <a:ext cx="4049445" cy="2186340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Flèche : droite 74">
              <a:extLst>
                <a:ext uri="{FF2B5EF4-FFF2-40B4-BE49-F238E27FC236}">
                  <a16:creationId xmlns:a16="http://schemas.microsoft.com/office/drawing/2014/main" id="{964DB4AC-F1B4-44AB-BEDB-C2C8045A63C5}"/>
                </a:ext>
              </a:extLst>
            </p:cNvPr>
            <p:cNvSpPr/>
            <p:nvPr/>
          </p:nvSpPr>
          <p:spPr>
            <a:xfrm rot="10008628">
              <a:off x="5542105" y="4264790"/>
              <a:ext cx="609599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Flèche : droite 75">
              <a:extLst>
                <a:ext uri="{FF2B5EF4-FFF2-40B4-BE49-F238E27FC236}">
                  <a16:creationId xmlns:a16="http://schemas.microsoft.com/office/drawing/2014/main" id="{2245A823-5CCD-4E69-886B-4AD3FD1759FB}"/>
                </a:ext>
              </a:extLst>
            </p:cNvPr>
            <p:cNvSpPr/>
            <p:nvPr/>
          </p:nvSpPr>
          <p:spPr>
            <a:xfrm rot="10008628">
              <a:off x="5446307" y="4720937"/>
              <a:ext cx="609599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Flèche : droite 76">
              <a:extLst>
                <a:ext uri="{FF2B5EF4-FFF2-40B4-BE49-F238E27FC236}">
                  <a16:creationId xmlns:a16="http://schemas.microsoft.com/office/drawing/2014/main" id="{BFA2C397-078D-4909-8B9F-4A8C6C422747}"/>
                </a:ext>
              </a:extLst>
            </p:cNvPr>
            <p:cNvSpPr/>
            <p:nvPr/>
          </p:nvSpPr>
          <p:spPr>
            <a:xfrm rot="20716014">
              <a:off x="3584080" y="2381140"/>
              <a:ext cx="609600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Flèche : droite 77">
              <a:extLst>
                <a:ext uri="{FF2B5EF4-FFF2-40B4-BE49-F238E27FC236}">
                  <a16:creationId xmlns:a16="http://schemas.microsoft.com/office/drawing/2014/main" id="{843EF1B4-0DFD-4D0F-8CB8-5FF3793BDEB8}"/>
                </a:ext>
              </a:extLst>
            </p:cNvPr>
            <p:cNvSpPr/>
            <p:nvPr/>
          </p:nvSpPr>
          <p:spPr>
            <a:xfrm rot="20716014">
              <a:off x="3673160" y="2857551"/>
              <a:ext cx="609600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Flèche : droite 78">
              <a:extLst>
                <a:ext uri="{FF2B5EF4-FFF2-40B4-BE49-F238E27FC236}">
                  <a16:creationId xmlns:a16="http://schemas.microsoft.com/office/drawing/2014/main" id="{04C24D0C-6AFF-493E-9C3C-72A43206E18B}"/>
                </a:ext>
              </a:extLst>
            </p:cNvPr>
            <p:cNvSpPr/>
            <p:nvPr/>
          </p:nvSpPr>
          <p:spPr>
            <a:xfrm rot="20716014">
              <a:off x="6656035" y="2709019"/>
              <a:ext cx="609600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Flèche : droite 79">
              <a:extLst>
                <a:ext uri="{FF2B5EF4-FFF2-40B4-BE49-F238E27FC236}">
                  <a16:creationId xmlns:a16="http://schemas.microsoft.com/office/drawing/2014/main" id="{98D49A4E-38CB-457F-9460-CDE6BCDF5DF9}"/>
                </a:ext>
              </a:extLst>
            </p:cNvPr>
            <p:cNvSpPr/>
            <p:nvPr/>
          </p:nvSpPr>
          <p:spPr>
            <a:xfrm rot="20716014">
              <a:off x="3738519" y="3321986"/>
              <a:ext cx="609600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Flèche : droite 80">
              <a:extLst>
                <a:ext uri="{FF2B5EF4-FFF2-40B4-BE49-F238E27FC236}">
                  <a16:creationId xmlns:a16="http://schemas.microsoft.com/office/drawing/2014/main" id="{14FEF11D-6E27-4DC1-846D-D22409C7CB18}"/>
                </a:ext>
              </a:extLst>
            </p:cNvPr>
            <p:cNvSpPr/>
            <p:nvPr/>
          </p:nvSpPr>
          <p:spPr>
            <a:xfrm rot="20716014">
              <a:off x="6477286" y="1822009"/>
              <a:ext cx="609600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Flèche : droite 81">
              <a:extLst>
                <a:ext uri="{FF2B5EF4-FFF2-40B4-BE49-F238E27FC236}">
                  <a16:creationId xmlns:a16="http://schemas.microsoft.com/office/drawing/2014/main" id="{86EE372A-6C2C-4372-BA56-A460A6948EC8}"/>
                </a:ext>
              </a:extLst>
            </p:cNvPr>
            <p:cNvSpPr/>
            <p:nvPr/>
          </p:nvSpPr>
          <p:spPr>
            <a:xfrm rot="20716014">
              <a:off x="6566366" y="2260320"/>
              <a:ext cx="609600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Flèche : droite 82">
              <a:extLst>
                <a:ext uri="{FF2B5EF4-FFF2-40B4-BE49-F238E27FC236}">
                  <a16:creationId xmlns:a16="http://schemas.microsoft.com/office/drawing/2014/main" id="{4BD38A1C-A595-4024-823C-F7AE434B01A0}"/>
                </a:ext>
              </a:extLst>
            </p:cNvPr>
            <p:cNvSpPr/>
            <p:nvPr/>
          </p:nvSpPr>
          <p:spPr>
            <a:xfrm rot="10008628">
              <a:off x="5656182" y="5080792"/>
              <a:ext cx="609600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Flèche : droite 83">
              <a:extLst>
                <a:ext uri="{FF2B5EF4-FFF2-40B4-BE49-F238E27FC236}">
                  <a16:creationId xmlns:a16="http://schemas.microsoft.com/office/drawing/2014/main" id="{D6CFCB23-9F3A-4522-98FB-DC45DDDB90DA}"/>
                </a:ext>
              </a:extLst>
            </p:cNvPr>
            <p:cNvSpPr/>
            <p:nvPr/>
          </p:nvSpPr>
          <p:spPr>
            <a:xfrm rot="10008628">
              <a:off x="3789840" y="4593413"/>
              <a:ext cx="609599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Flèche : droite 84">
              <a:extLst>
                <a:ext uri="{FF2B5EF4-FFF2-40B4-BE49-F238E27FC236}">
                  <a16:creationId xmlns:a16="http://schemas.microsoft.com/office/drawing/2014/main" id="{06A4E648-1C57-4B45-9684-BFE5A0983E4B}"/>
                </a:ext>
              </a:extLst>
            </p:cNvPr>
            <p:cNvSpPr/>
            <p:nvPr/>
          </p:nvSpPr>
          <p:spPr>
            <a:xfrm rot="10008628">
              <a:off x="3813506" y="5066217"/>
              <a:ext cx="609599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Flèche : droite 85">
              <a:extLst>
                <a:ext uri="{FF2B5EF4-FFF2-40B4-BE49-F238E27FC236}">
                  <a16:creationId xmlns:a16="http://schemas.microsoft.com/office/drawing/2014/main" id="{65C3A080-2390-4ED1-8AAD-EE03FF37293F}"/>
                </a:ext>
              </a:extLst>
            </p:cNvPr>
            <p:cNvSpPr/>
            <p:nvPr/>
          </p:nvSpPr>
          <p:spPr>
            <a:xfrm rot="10008628">
              <a:off x="3819045" y="5493093"/>
              <a:ext cx="609600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Flèche : droite 86">
              <a:extLst>
                <a:ext uri="{FF2B5EF4-FFF2-40B4-BE49-F238E27FC236}">
                  <a16:creationId xmlns:a16="http://schemas.microsoft.com/office/drawing/2014/main" id="{A5CE1436-CFFD-4DF1-A0E8-B2E6F88DC29F}"/>
                </a:ext>
              </a:extLst>
            </p:cNvPr>
            <p:cNvSpPr/>
            <p:nvPr/>
          </p:nvSpPr>
          <p:spPr>
            <a:xfrm>
              <a:off x="9279165" y="6487569"/>
              <a:ext cx="609599" cy="170360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9" name="Groupe 88">
              <a:extLst>
                <a:ext uri="{FF2B5EF4-FFF2-40B4-BE49-F238E27FC236}">
                  <a16:creationId xmlns:a16="http://schemas.microsoft.com/office/drawing/2014/main" id="{8A2A68DC-DA5D-4965-8BD7-36CE392D172A}"/>
                </a:ext>
              </a:extLst>
            </p:cNvPr>
            <p:cNvGrpSpPr/>
            <p:nvPr/>
          </p:nvGrpSpPr>
          <p:grpSpPr>
            <a:xfrm>
              <a:off x="6010378" y="1089134"/>
              <a:ext cx="45719" cy="557462"/>
              <a:chOff x="5654166" y="4212184"/>
              <a:chExt cx="69011" cy="637272"/>
            </a:xfrm>
            <a:solidFill>
              <a:schemeClr val="accent4">
                <a:lumMod val="60000"/>
                <a:lumOff val="40000"/>
              </a:schemeClr>
            </a:solidFill>
          </p:grpSpPr>
          <p:cxnSp>
            <p:nvCxnSpPr>
              <p:cNvPr id="90" name="Connecteur droit 89">
                <a:extLst>
                  <a:ext uri="{FF2B5EF4-FFF2-40B4-BE49-F238E27FC236}">
                    <a16:creationId xmlns:a16="http://schemas.microsoft.com/office/drawing/2014/main" id="{8C631993-4970-4E49-A426-93A4DEC4B21A}"/>
                  </a:ext>
                </a:extLst>
              </p:cNvPr>
              <p:cNvCxnSpPr/>
              <p:nvPr/>
            </p:nvCxnSpPr>
            <p:spPr>
              <a:xfrm>
                <a:off x="5688672" y="4212184"/>
                <a:ext cx="0" cy="377057"/>
              </a:xfrm>
              <a:prstGeom prst="line">
                <a:avLst/>
              </a:prstGeom>
              <a:grp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id="{EF5CD5DE-A8FD-4248-AE69-0F6ACB5BCEC4}"/>
                  </a:ext>
                </a:extLst>
              </p:cNvPr>
              <p:cNvSpPr/>
              <p:nvPr/>
            </p:nvSpPr>
            <p:spPr>
              <a:xfrm>
                <a:off x="5654166" y="4585804"/>
                <a:ext cx="69011" cy="263652"/>
              </a:xfrm>
              <a:prstGeom prst="rect">
                <a:avLst/>
              </a:prstGeom>
              <a:grp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4" name="Groupe 93">
              <a:extLst>
                <a:ext uri="{FF2B5EF4-FFF2-40B4-BE49-F238E27FC236}">
                  <a16:creationId xmlns:a16="http://schemas.microsoft.com/office/drawing/2014/main" id="{93041C00-57A5-4577-9656-B40E338B4524}"/>
                </a:ext>
              </a:extLst>
            </p:cNvPr>
            <p:cNvGrpSpPr/>
            <p:nvPr/>
          </p:nvGrpSpPr>
          <p:grpSpPr>
            <a:xfrm>
              <a:off x="5161281" y="1298978"/>
              <a:ext cx="45719" cy="557462"/>
              <a:chOff x="5654166" y="4212184"/>
              <a:chExt cx="69011" cy="637272"/>
            </a:xfrm>
            <a:solidFill>
              <a:schemeClr val="accent4">
                <a:lumMod val="60000"/>
                <a:lumOff val="40000"/>
              </a:schemeClr>
            </a:solidFill>
          </p:grpSpPr>
          <p:cxnSp>
            <p:nvCxnSpPr>
              <p:cNvPr id="95" name="Connecteur droit 94">
                <a:extLst>
                  <a:ext uri="{FF2B5EF4-FFF2-40B4-BE49-F238E27FC236}">
                    <a16:creationId xmlns:a16="http://schemas.microsoft.com/office/drawing/2014/main" id="{AF6289A8-7936-4F1A-877F-CBBE8EE707FF}"/>
                  </a:ext>
                </a:extLst>
              </p:cNvPr>
              <p:cNvCxnSpPr/>
              <p:nvPr/>
            </p:nvCxnSpPr>
            <p:spPr>
              <a:xfrm>
                <a:off x="5688672" y="4212184"/>
                <a:ext cx="0" cy="377057"/>
              </a:xfrm>
              <a:prstGeom prst="line">
                <a:avLst/>
              </a:prstGeom>
              <a:grp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id="{49D33B85-BEDF-4AC9-85DD-0E308CD49680}"/>
                  </a:ext>
                </a:extLst>
              </p:cNvPr>
              <p:cNvSpPr/>
              <p:nvPr/>
            </p:nvSpPr>
            <p:spPr>
              <a:xfrm>
                <a:off x="5654166" y="4585804"/>
                <a:ext cx="69011" cy="263652"/>
              </a:xfrm>
              <a:prstGeom prst="rect">
                <a:avLst/>
              </a:prstGeom>
              <a:grp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7" name="Groupe 96">
              <a:extLst>
                <a:ext uri="{FF2B5EF4-FFF2-40B4-BE49-F238E27FC236}">
                  <a16:creationId xmlns:a16="http://schemas.microsoft.com/office/drawing/2014/main" id="{2A461412-F0B0-4DC4-B1AB-61E4F0180007}"/>
                </a:ext>
              </a:extLst>
            </p:cNvPr>
            <p:cNvGrpSpPr/>
            <p:nvPr/>
          </p:nvGrpSpPr>
          <p:grpSpPr>
            <a:xfrm>
              <a:off x="4200060" y="1527886"/>
              <a:ext cx="45719" cy="557462"/>
              <a:chOff x="5654166" y="4212184"/>
              <a:chExt cx="69011" cy="637272"/>
            </a:xfrm>
            <a:solidFill>
              <a:schemeClr val="accent4">
                <a:lumMod val="60000"/>
                <a:lumOff val="40000"/>
              </a:schemeClr>
            </a:solidFill>
          </p:grpSpPr>
          <p:cxnSp>
            <p:nvCxnSpPr>
              <p:cNvPr id="98" name="Connecteur droit 97">
                <a:extLst>
                  <a:ext uri="{FF2B5EF4-FFF2-40B4-BE49-F238E27FC236}">
                    <a16:creationId xmlns:a16="http://schemas.microsoft.com/office/drawing/2014/main" id="{5C728654-696D-4455-8327-E0359E9D36A7}"/>
                  </a:ext>
                </a:extLst>
              </p:cNvPr>
              <p:cNvCxnSpPr/>
              <p:nvPr/>
            </p:nvCxnSpPr>
            <p:spPr>
              <a:xfrm>
                <a:off x="5688672" y="4212184"/>
                <a:ext cx="0" cy="377057"/>
              </a:xfrm>
              <a:prstGeom prst="line">
                <a:avLst/>
              </a:prstGeom>
              <a:grp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07B30A7E-3853-495D-BE27-DADA12DBAE28}"/>
                  </a:ext>
                </a:extLst>
              </p:cNvPr>
              <p:cNvSpPr/>
              <p:nvPr/>
            </p:nvSpPr>
            <p:spPr>
              <a:xfrm>
                <a:off x="5654166" y="4585804"/>
                <a:ext cx="69011" cy="263652"/>
              </a:xfrm>
              <a:prstGeom prst="rect">
                <a:avLst/>
              </a:prstGeom>
              <a:grp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00" name="Connecteur droit 99">
              <a:extLst>
                <a:ext uri="{FF2B5EF4-FFF2-40B4-BE49-F238E27FC236}">
                  <a16:creationId xmlns:a16="http://schemas.microsoft.com/office/drawing/2014/main" id="{86C3144A-1779-4B21-B3C1-44901BDAF79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171202" y="856592"/>
              <a:ext cx="59275" cy="1108387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necteur droit 100">
              <a:extLst>
                <a:ext uri="{FF2B5EF4-FFF2-40B4-BE49-F238E27FC236}">
                  <a16:creationId xmlns:a16="http://schemas.microsoft.com/office/drawing/2014/main" id="{35F9F7AB-D981-4AC4-8EF4-E9CC3EBDE354}"/>
                </a:ext>
              </a:extLst>
            </p:cNvPr>
            <p:cNvCxnSpPr>
              <a:cxnSpLocks/>
              <a:stCxn id="96" idx="3"/>
            </p:cNvCxnSpPr>
            <p:nvPr/>
          </p:nvCxnSpPr>
          <p:spPr>
            <a:xfrm flipH="1" flipV="1">
              <a:off x="4200060" y="876307"/>
              <a:ext cx="1006940" cy="864817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cteur droit 101">
              <a:extLst>
                <a:ext uri="{FF2B5EF4-FFF2-40B4-BE49-F238E27FC236}">
                  <a16:creationId xmlns:a16="http://schemas.microsoft.com/office/drawing/2014/main" id="{E274FA62-DF25-48F0-B558-E63ED6E11A9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16505" y="1041242"/>
              <a:ext cx="4602750" cy="1179347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cteur droit 102">
              <a:extLst>
                <a:ext uri="{FF2B5EF4-FFF2-40B4-BE49-F238E27FC236}">
                  <a16:creationId xmlns:a16="http://schemas.microsoft.com/office/drawing/2014/main" id="{7D527BDE-16C9-42E1-8C1F-97BBC6DC2882}"/>
                </a:ext>
              </a:extLst>
            </p:cNvPr>
            <p:cNvCxnSpPr>
              <a:cxnSpLocks/>
              <a:stCxn id="93" idx="3"/>
            </p:cNvCxnSpPr>
            <p:nvPr/>
          </p:nvCxnSpPr>
          <p:spPr>
            <a:xfrm flipH="1" flipV="1">
              <a:off x="4163917" y="854696"/>
              <a:ext cx="1892180" cy="676584"/>
            </a:xfrm>
            <a:prstGeom prst="line">
              <a:avLst/>
            </a:prstGeom>
            <a:ln w="28575">
              <a:solidFill>
                <a:schemeClr val="tx1"/>
              </a:solidFill>
              <a:headEnd type="stealth"/>
              <a:tailEnd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BAC1ADAC-FFCA-46E1-9DF7-C9EAD04F9810}"/>
                </a:ext>
              </a:extLst>
            </p:cNvPr>
            <p:cNvSpPr/>
            <p:nvPr/>
          </p:nvSpPr>
          <p:spPr>
            <a:xfrm>
              <a:off x="3036472" y="152045"/>
              <a:ext cx="2398439" cy="631294"/>
            </a:xfrm>
            <a:prstGeom prst="rect">
              <a:avLst/>
            </a:prstGeom>
            <a:ln w="28575"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°C and %HR sensors for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and regulation </a:t>
              </a:r>
            </a:p>
          </p:txBody>
        </p:sp>
        <p:sp>
          <p:nvSpPr>
            <p:cNvPr id="108" name="Organigramme : Terminateur 107">
              <a:extLst>
                <a:ext uri="{FF2B5EF4-FFF2-40B4-BE49-F238E27FC236}">
                  <a16:creationId xmlns:a16="http://schemas.microsoft.com/office/drawing/2014/main" id="{B56108D3-AA26-4741-A33E-A79D214B5E4A}"/>
                </a:ext>
              </a:extLst>
            </p:cNvPr>
            <p:cNvSpPr/>
            <p:nvPr/>
          </p:nvSpPr>
          <p:spPr>
            <a:xfrm rot="19639707">
              <a:off x="6423216" y="3925209"/>
              <a:ext cx="167792" cy="590238"/>
            </a:xfrm>
            <a:prstGeom prst="flowChartTerminator">
              <a:avLst/>
            </a:prstGeom>
            <a:solidFill>
              <a:srgbClr val="6A59D3"/>
            </a:solidFill>
            <a:ln>
              <a:solidFill>
                <a:srgbClr val="6A59D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Organigramme : Terminateur 108">
              <a:extLst>
                <a:ext uri="{FF2B5EF4-FFF2-40B4-BE49-F238E27FC236}">
                  <a16:creationId xmlns:a16="http://schemas.microsoft.com/office/drawing/2014/main" id="{A9C4F642-65DC-4894-AB4D-C4F35790A59F}"/>
                </a:ext>
              </a:extLst>
            </p:cNvPr>
            <p:cNvSpPr/>
            <p:nvPr/>
          </p:nvSpPr>
          <p:spPr>
            <a:xfrm rot="12824249">
              <a:off x="6471170" y="4824871"/>
              <a:ext cx="167792" cy="590238"/>
            </a:xfrm>
            <a:prstGeom prst="flowChartTerminator">
              <a:avLst/>
            </a:prstGeom>
            <a:solidFill>
              <a:srgbClr val="6A59D3"/>
            </a:solidFill>
            <a:ln>
              <a:solidFill>
                <a:srgbClr val="6A59D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4" name="ZoneTexte 123">
            <a:extLst>
              <a:ext uri="{FF2B5EF4-FFF2-40B4-BE49-F238E27FC236}">
                <a16:creationId xmlns:a16="http://schemas.microsoft.com/office/drawing/2014/main" id="{78EC684D-EC88-4E6F-B12F-9EE8D2CCD26A}"/>
              </a:ext>
            </a:extLst>
          </p:cNvPr>
          <p:cNvSpPr txBox="1"/>
          <p:nvPr/>
        </p:nvSpPr>
        <p:spPr>
          <a:xfrm>
            <a:off x="10853484" y="5822997"/>
            <a:ext cx="11128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ir flow direction</a:t>
            </a:r>
          </a:p>
        </p:txBody>
      </p:sp>
      <p:sp>
        <p:nvSpPr>
          <p:cNvPr id="128" name="Flèche : droite 127">
            <a:extLst>
              <a:ext uri="{FF2B5EF4-FFF2-40B4-BE49-F238E27FC236}">
                <a16:creationId xmlns:a16="http://schemas.microsoft.com/office/drawing/2014/main" id="{EDDC9069-00FD-439C-B101-52B46D3B1376}"/>
              </a:ext>
            </a:extLst>
          </p:cNvPr>
          <p:cNvSpPr/>
          <p:nvPr/>
        </p:nvSpPr>
        <p:spPr>
          <a:xfrm rot="10008628">
            <a:off x="8348204" y="4281514"/>
            <a:ext cx="386360" cy="107973"/>
          </a:xfrm>
          <a:prstGeom prst="rightArrow">
            <a:avLst/>
          </a:prstGeom>
          <a:solidFill>
            <a:schemeClr val="accent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47359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</a:spPr>
      <a:bodyPr rtlCol="0" anchor="ctr"/>
      <a:lstStyle>
        <a:defPPr algn="ctr">
          <a:defRPr sz="1400" dirty="0" smtClean="0">
            <a:ln>
              <a:solidFill>
                <a:sysClr val="windowText" lastClr="000000"/>
              </a:solidFill>
            </a:ln>
            <a:solidFill>
              <a:sysClr val="windowText" lastClr="000000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0</TotalTime>
  <Words>343</Words>
  <Application>Microsoft Office PowerPoint</Application>
  <PresentationFormat>Widescreen</PresentationFormat>
  <Paragraphs>7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Michel MEOT</dc:creator>
  <cp:lastModifiedBy>MDPI</cp:lastModifiedBy>
  <cp:revision>72</cp:revision>
  <dcterms:created xsi:type="dcterms:W3CDTF">2022-02-12T08:12:38Z</dcterms:created>
  <dcterms:modified xsi:type="dcterms:W3CDTF">2022-02-23T09:10:11Z</dcterms:modified>
</cp:coreProperties>
</file>